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8" r:id="rId1"/>
    <p:sldMasterId id="2147483680" r:id="rId2"/>
    <p:sldMasterId id="2147483820" r:id="rId3"/>
  </p:sldMasterIdLst>
  <p:sldIdLst>
    <p:sldId id="257" r:id="rId4"/>
    <p:sldId id="258" r:id="rId5"/>
  </p:sldIdLst>
  <p:sldSz cx="9144000" cy="6858000" type="screen4x3"/>
  <p:notesSz cx="6858000" cy="9144000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956" autoAdjust="0"/>
  </p:normalViewPr>
  <p:slideViewPr>
    <p:cSldViewPr snapToGrid="0" snapToObjects="1">
      <p:cViewPr>
        <p:scale>
          <a:sx n="103" d="100"/>
          <a:sy n="103" d="100"/>
        </p:scale>
        <p:origin x="-1504" y="-4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Master" Target="slideMasters/slideMaster3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loriana:Desktop:POLICLINICO:PloOne:revisione%202018:Row%20data%20animal%20experiment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loriana:Desktop:POLICLINICO:PloOne:revisione%202018:Row%20data%20animal%20experiment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loriana:Desktop:POLICLINICO:PloOne:revisione%202018:Row%20data%20animal%20experiment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Microsoft_Excel1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Microsoft_Excel2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Microsoft_Excel3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Microsoft_Excel4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Microsoft_Excel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CALU-3 ERL-R</a:t>
            </a:r>
          </a:p>
        </c:rich>
      </c:tx>
      <c:layout>
        <c:manualLayout>
          <c:xMode val="edge"/>
          <c:yMode val="edge"/>
          <c:x val="0.352826170701265"/>
          <c:y val="0.0267559801470314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13502881192438"/>
          <c:y val="0.180094890920567"/>
          <c:w val="0.700586749429184"/>
          <c:h val="0.649289475160991"/>
        </c:manualLayout>
      </c:layout>
      <c:lineChart>
        <c:grouping val="standard"/>
        <c:varyColors val="0"/>
        <c:ser>
          <c:idx val="0"/>
          <c:order val="0"/>
          <c:tx>
            <c:strRef>
              <c:f>'CALU-3 GRAPH'!$A$42</c:f>
              <c:strCache>
                <c:ptCount val="1"/>
                <c:pt idx="0">
                  <c:v>CTR</c:v>
                </c:pt>
              </c:strCache>
            </c:strRef>
          </c:tx>
          <c:spPr>
            <a:ln w="25400">
              <a:solidFill>
                <a:srgbClr val="808080"/>
              </a:solidFill>
              <a:prstDash val="solid"/>
            </a:ln>
          </c:spPr>
          <c:marker>
            <c:spPr>
              <a:solidFill>
                <a:srgbClr val="616161"/>
              </a:solidFill>
              <a:ln>
                <a:solidFill>
                  <a:srgbClr val="80808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ALU-3 GRAPH'!$B$48:$P$48</c:f>
                <c:numCache>
                  <c:formatCode>General</c:formatCode>
                  <c:ptCount val="15"/>
                  <c:pt idx="0">
                    <c:v>7.424300892638215</c:v>
                  </c:pt>
                  <c:pt idx="1">
                    <c:v>5.13598139528715</c:v>
                  </c:pt>
                  <c:pt idx="2">
                    <c:v>7.314256268206622</c:v>
                  </c:pt>
                  <c:pt idx="3">
                    <c:v>20.59609659925479</c:v>
                  </c:pt>
                  <c:pt idx="4">
                    <c:v>19.66920774052318</c:v>
                  </c:pt>
                  <c:pt idx="5">
                    <c:v>8.596867494743168</c:v>
                  </c:pt>
                  <c:pt idx="6">
                    <c:v>22.112266262346</c:v>
                  </c:pt>
                  <c:pt idx="7">
                    <c:v>11.38433052705466</c:v>
                  </c:pt>
                  <c:pt idx="8">
                    <c:v>12.64981451014316</c:v>
                  </c:pt>
                  <c:pt idx="9">
                    <c:v>16.94598930897472</c:v>
                  </c:pt>
                  <c:pt idx="10">
                    <c:v>18.98768033470048</c:v>
                  </c:pt>
                  <c:pt idx="11">
                    <c:v>7.361092159701888</c:v>
                  </c:pt>
                  <c:pt idx="12">
                    <c:v>7.862650695448394</c:v>
                  </c:pt>
                  <c:pt idx="13">
                    <c:v>22.47868420132135</c:v>
                  </c:pt>
                  <c:pt idx="14">
                    <c:v>24.30243055938218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'CALU-3 GRAPH'!$B$41:$P$41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CALU-3 GRAPH'!$B$42:$P$42</c:f>
              <c:numCache>
                <c:formatCode>0</c:formatCode>
                <c:ptCount val="15"/>
                <c:pt idx="0">
                  <c:v>75.720905</c:v>
                </c:pt>
                <c:pt idx="1">
                  <c:v>100.0839775</c:v>
                </c:pt>
                <c:pt idx="2">
                  <c:v>145.314455</c:v>
                </c:pt>
                <c:pt idx="3">
                  <c:v>155.42267</c:v>
                </c:pt>
                <c:pt idx="4">
                  <c:v>189.046845</c:v>
                </c:pt>
                <c:pt idx="5">
                  <c:v>211.15185</c:v>
                </c:pt>
                <c:pt idx="6">
                  <c:v>229.497645</c:v>
                </c:pt>
                <c:pt idx="7">
                  <c:v>261.2506650000001</c:v>
                </c:pt>
                <c:pt idx="8">
                  <c:v>288.91642</c:v>
                </c:pt>
                <c:pt idx="9">
                  <c:v>301.4130599999998</c:v>
                </c:pt>
                <c:pt idx="10">
                  <c:v>345.2800649999999</c:v>
                </c:pt>
                <c:pt idx="11">
                  <c:v>387.749414</c:v>
                </c:pt>
                <c:pt idx="12">
                  <c:v>400.5077764999999</c:v>
                </c:pt>
                <c:pt idx="13">
                  <c:v>436.2391474999998</c:v>
                </c:pt>
                <c:pt idx="14">
                  <c:v>570.090852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CALU-3 GRAPH'!$A$43</c:f>
              <c:strCache>
                <c:ptCount val="1"/>
                <c:pt idx="0">
                  <c:v>sorafenib</c:v>
                </c:pt>
              </c:strCache>
            </c:strRef>
          </c:tx>
          <c:spPr>
            <a:ln w="25400">
              <a:solidFill>
                <a:srgbClr val="C0C0C0"/>
              </a:solidFill>
              <a:prstDash val="solid"/>
            </a:ln>
          </c:spPr>
          <c:marker>
            <c:spPr>
              <a:solidFill>
                <a:srgbClr val="B3B3B3"/>
              </a:solidFill>
              <a:ln>
                <a:solidFill>
                  <a:srgbClr val="C0C0C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ALU-3 GRAPH'!$B$49:$P$49</c:f>
                <c:numCache>
                  <c:formatCode>General</c:formatCode>
                  <c:ptCount val="15"/>
                  <c:pt idx="0">
                    <c:v>12.11290248915471</c:v>
                  </c:pt>
                  <c:pt idx="1">
                    <c:v>14.40573422984398</c:v>
                  </c:pt>
                  <c:pt idx="2">
                    <c:v>20.87160819781325</c:v>
                  </c:pt>
                  <c:pt idx="3">
                    <c:v>17.20551498397487</c:v>
                  </c:pt>
                  <c:pt idx="4">
                    <c:v>23.55284558482663</c:v>
                  </c:pt>
                  <c:pt idx="5">
                    <c:v>31.12934310968579</c:v>
                  </c:pt>
                  <c:pt idx="6">
                    <c:v>37.69739415231595</c:v>
                  </c:pt>
                  <c:pt idx="7">
                    <c:v>14.0838034892759</c:v>
                  </c:pt>
                  <c:pt idx="8">
                    <c:v>10.24246389169967</c:v>
                  </c:pt>
                  <c:pt idx="9">
                    <c:v>11.87985450943981</c:v>
                  </c:pt>
                  <c:pt idx="10">
                    <c:v>15.04713997166337</c:v>
                  </c:pt>
                  <c:pt idx="11">
                    <c:v>17.93532058569102</c:v>
                  </c:pt>
                  <c:pt idx="12">
                    <c:v>24.43708941582912</c:v>
                  </c:pt>
                  <c:pt idx="13">
                    <c:v>22.6757898229197</c:v>
                  </c:pt>
                  <c:pt idx="14">
                    <c:v>20.23865833195681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'CALU-3 GRAPH'!$B$41:$P$41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CALU-3 GRAPH'!$B$43:$P$43</c:f>
              <c:numCache>
                <c:formatCode>0</c:formatCode>
                <c:ptCount val="15"/>
                <c:pt idx="0">
                  <c:v>75.84018</c:v>
                </c:pt>
                <c:pt idx="1">
                  <c:v>86.86928899999998</c:v>
                </c:pt>
                <c:pt idx="2">
                  <c:v>90.60886899999997</c:v>
                </c:pt>
                <c:pt idx="3">
                  <c:v>95.777994</c:v>
                </c:pt>
                <c:pt idx="4">
                  <c:v>105.507649</c:v>
                </c:pt>
                <c:pt idx="5">
                  <c:v>109.302024</c:v>
                </c:pt>
                <c:pt idx="6">
                  <c:v>113.7877715</c:v>
                </c:pt>
                <c:pt idx="7">
                  <c:v>116.035465</c:v>
                </c:pt>
                <c:pt idx="8">
                  <c:v>118.534975</c:v>
                </c:pt>
                <c:pt idx="9">
                  <c:v>127.431915</c:v>
                </c:pt>
                <c:pt idx="10">
                  <c:v>128.795355</c:v>
                </c:pt>
                <c:pt idx="11">
                  <c:v>129.947545</c:v>
                </c:pt>
                <c:pt idx="12">
                  <c:v>132.415335</c:v>
                </c:pt>
                <c:pt idx="13">
                  <c:v>135.078385</c:v>
                </c:pt>
                <c:pt idx="14">
                  <c:v>141.36960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09323640"/>
        <c:axId val="2094378552"/>
      </c:lineChart>
      <c:catAx>
        <c:axId val="2109323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209437855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094378552"/>
        <c:scaling>
          <c:orientation val="minMax"/>
        </c:scaling>
        <c:delete val="0"/>
        <c:axPos val="l"/>
        <c:majorGridlines>
          <c:spPr>
            <a:ln w="3175">
              <a:solidFill>
                <a:srgbClr val="80808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umor size (mm</a:t>
                </a:r>
                <a:r>
                  <a:rPr lang="it-IT" baseline="30000"/>
                  <a:t>3</a:t>
                </a:r>
                <a:r>
                  <a:rPr lang="it-IT"/>
                  <a:t>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210932364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it-IT"/>
              <a:t>CALU-3 VAN-R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11984363477208"/>
          <c:y val="0.175115601408593"/>
          <c:w val="0.701375750199354"/>
          <c:h val="0.663595963232564"/>
        </c:manualLayout>
      </c:layout>
      <c:lineChart>
        <c:grouping val="standard"/>
        <c:varyColors val="0"/>
        <c:ser>
          <c:idx val="0"/>
          <c:order val="0"/>
          <c:tx>
            <c:strRef>
              <c:f>'CALU-3 GRAPH'!$A$117</c:f>
              <c:strCache>
                <c:ptCount val="1"/>
                <c:pt idx="0">
                  <c:v>CTR</c:v>
                </c:pt>
              </c:strCache>
            </c:strRef>
          </c:tx>
          <c:spPr>
            <a:ln w="25400">
              <a:solidFill>
                <a:srgbClr val="808080"/>
              </a:solidFill>
              <a:prstDash val="solid"/>
            </a:ln>
          </c:spPr>
          <c:marker>
            <c:spPr>
              <a:solidFill>
                <a:srgbClr val="616161"/>
              </a:solidFill>
              <a:ln>
                <a:solidFill>
                  <a:srgbClr val="80808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ALU-3 GRAPH'!$B$125:$P$125</c:f>
                <c:numCache>
                  <c:formatCode>General</c:formatCode>
                  <c:ptCount val="15"/>
                  <c:pt idx="0">
                    <c:v>3.883206397066914</c:v>
                  </c:pt>
                  <c:pt idx="1">
                    <c:v>13.20863158488174</c:v>
                  </c:pt>
                  <c:pt idx="2">
                    <c:v>7.667165873938403</c:v>
                  </c:pt>
                  <c:pt idx="3">
                    <c:v>14.53725255017703</c:v>
                  </c:pt>
                  <c:pt idx="4">
                    <c:v>21.94082383050613</c:v>
                  </c:pt>
                  <c:pt idx="5">
                    <c:v>20.51862123533922</c:v>
                  </c:pt>
                  <c:pt idx="6">
                    <c:v>18.68553632134681</c:v>
                  </c:pt>
                  <c:pt idx="7">
                    <c:v>7.742216123339726</c:v>
                  </c:pt>
                  <c:pt idx="8">
                    <c:v>14.9912169780399</c:v>
                  </c:pt>
                  <c:pt idx="9">
                    <c:v>21.35907177516158</c:v>
                  </c:pt>
                  <c:pt idx="10">
                    <c:v>6.599562293355952</c:v>
                  </c:pt>
                  <c:pt idx="11">
                    <c:v>12.12900470232261</c:v>
                  </c:pt>
                  <c:pt idx="12">
                    <c:v>31.34708382817175</c:v>
                  </c:pt>
                  <c:pt idx="13">
                    <c:v>18.90928485026446</c:v>
                  </c:pt>
                  <c:pt idx="14">
                    <c:v>24.66028262113992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'CALU-3 GRAPH'!$B$116:$P$116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CALU-3 GRAPH'!$B$117:$P$117</c:f>
              <c:numCache>
                <c:formatCode>0</c:formatCode>
                <c:ptCount val="15"/>
                <c:pt idx="0">
                  <c:v>75.18150250000001</c:v>
                </c:pt>
                <c:pt idx="1">
                  <c:v>125.0890875</c:v>
                </c:pt>
                <c:pt idx="2">
                  <c:v>149.955455</c:v>
                </c:pt>
                <c:pt idx="3">
                  <c:v>180.095045</c:v>
                </c:pt>
                <c:pt idx="4">
                  <c:v>214.9655625</c:v>
                </c:pt>
                <c:pt idx="5">
                  <c:v>240.15368</c:v>
                </c:pt>
                <c:pt idx="6">
                  <c:v>281.1296345000001</c:v>
                </c:pt>
                <c:pt idx="7">
                  <c:v>309.9321549999998</c:v>
                </c:pt>
                <c:pt idx="8">
                  <c:v>350.0238885</c:v>
                </c:pt>
                <c:pt idx="9">
                  <c:v>380.0912959999998</c:v>
                </c:pt>
                <c:pt idx="10">
                  <c:v>411.4176299999999</c:v>
                </c:pt>
                <c:pt idx="11">
                  <c:v>439.9615024999998</c:v>
                </c:pt>
                <c:pt idx="12">
                  <c:v>481.507546</c:v>
                </c:pt>
                <c:pt idx="13">
                  <c:v>531.3748765</c:v>
                </c:pt>
                <c:pt idx="14">
                  <c:v>599.444273999999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CALU-3 GRAPH'!$A$118</c:f>
              <c:strCache>
                <c:ptCount val="1"/>
                <c:pt idx="0">
                  <c:v>sorafenib</c:v>
                </c:pt>
              </c:strCache>
            </c:strRef>
          </c:tx>
          <c:spPr>
            <a:ln w="25400">
              <a:solidFill>
                <a:srgbClr val="C0C0C0"/>
              </a:solidFill>
              <a:prstDash val="solid"/>
            </a:ln>
          </c:spPr>
          <c:marker>
            <c:spPr>
              <a:solidFill>
                <a:srgbClr val="B3B3B3"/>
              </a:solidFill>
              <a:ln>
                <a:solidFill>
                  <a:srgbClr val="C0C0C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ALU-3 GRAPH'!$B$126:$P$126</c:f>
                <c:numCache>
                  <c:formatCode>General</c:formatCode>
                  <c:ptCount val="15"/>
                  <c:pt idx="0">
                    <c:v>11.27416148385556</c:v>
                  </c:pt>
                  <c:pt idx="1">
                    <c:v>16.20292382870272</c:v>
                  </c:pt>
                  <c:pt idx="2">
                    <c:v>23.59855345283867</c:v>
                  </c:pt>
                  <c:pt idx="3">
                    <c:v>33.17730791124853</c:v>
                  </c:pt>
                  <c:pt idx="4">
                    <c:v>23.27243878132342</c:v>
                  </c:pt>
                  <c:pt idx="5">
                    <c:v>15.95097685306311</c:v>
                  </c:pt>
                  <c:pt idx="6">
                    <c:v>14.9038943731393</c:v>
                  </c:pt>
                  <c:pt idx="7">
                    <c:v>21.97977237374423</c:v>
                  </c:pt>
                  <c:pt idx="8">
                    <c:v>16.3045436215968</c:v>
                  </c:pt>
                  <c:pt idx="9">
                    <c:v>9.81758467694382</c:v>
                  </c:pt>
                  <c:pt idx="10">
                    <c:v>23.76051850056888</c:v>
                  </c:pt>
                  <c:pt idx="11">
                    <c:v>23.84415913398372</c:v>
                  </c:pt>
                  <c:pt idx="12">
                    <c:v>17.84151770608572</c:v>
                  </c:pt>
                  <c:pt idx="13">
                    <c:v>12.57311772625782</c:v>
                  </c:pt>
                  <c:pt idx="14">
                    <c:v>6.512352608833811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numRef>
              <c:f>'CALU-3 GRAPH'!$B$116:$P$116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CALU-3 GRAPH'!$B$118:$P$118</c:f>
              <c:numCache>
                <c:formatCode>0</c:formatCode>
                <c:ptCount val="15"/>
                <c:pt idx="0">
                  <c:v>75.59334249999998</c:v>
                </c:pt>
                <c:pt idx="1">
                  <c:v>80.12692999999998</c:v>
                </c:pt>
                <c:pt idx="2">
                  <c:v>99.953815</c:v>
                </c:pt>
                <c:pt idx="3">
                  <c:v>120.284255</c:v>
                </c:pt>
                <c:pt idx="4">
                  <c:v>130.0903175</c:v>
                </c:pt>
                <c:pt idx="5">
                  <c:v>135.028582</c:v>
                </c:pt>
                <c:pt idx="6">
                  <c:v>145.0280195</c:v>
                </c:pt>
                <c:pt idx="7">
                  <c:v>163.7238395</c:v>
                </c:pt>
                <c:pt idx="8">
                  <c:v>178.59722075</c:v>
                </c:pt>
                <c:pt idx="9">
                  <c:v>191.2789645</c:v>
                </c:pt>
                <c:pt idx="10">
                  <c:v>205.023234</c:v>
                </c:pt>
                <c:pt idx="11">
                  <c:v>215.12946</c:v>
                </c:pt>
                <c:pt idx="12">
                  <c:v>223.54306</c:v>
                </c:pt>
                <c:pt idx="13">
                  <c:v>231.097841</c:v>
                </c:pt>
                <c:pt idx="14">
                  <c:v>241.30185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07134616"/>
        <c:axId val="2109599480"/>
      </c:lineChart>
      <c:catAx>
        <c:axId val="2107134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2109599480"/>
        <c:crosses val="autoZero"/>
        <c:auto val="1"/>
        <c:lblAlgn val="ctr"/>
        <c:lblOffset val="100"/>
        <c:noMultiLvlLbl val="0"/>
      </c:catAx>
      <c:valAx>
        <c:axId val="2109599480"/>
        <c:scaling>
          <c:orientation val="minMax"/>
          <c:max val="600.0"/>
        </c:scaling>
        <c:delete val="0"/>
        <c:axPos val="l"/>
        <c:majorGridlines>
          <c:spPr>
            <a:ln w="3175">
              <a:solidFill>
                <a:srgbClr val="80808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umor size (mm</a:t>
                </a:r>
                <a:r>
                  <a:rPr lang="it-IT" baseline="30000"/>
                  <a:t>3</a:t>
                </a:r>
                <a:r>
                  <a:rPr lang="it-IT"/>
                  <a:t>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2107134616"/>
        <c:crosses val="autoZero"/>
        <c:crossBetween val="between"/>
        <c:minorUnit val="10.0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it-IT"/>
              <a:t>CALU-3 WT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1328125"/>
          <c:y val="0.180094890920567"/>
          <c:w val="0.701171875"/>
          <c:h val="0.649289475160991"/>
        </c:manualLayout>
      </c:layout>
      <c:lineChart>
        <c:grouping val="standard"/>
        <c:varyColors val="0"/>
        <c:ser>
          <c:idx val="0"/>
          <c:order val="0"/>
          <c:tx>
            <c:strRef>
              <c:f>'CALU-3 GRAPH'!$A$6</c:f>
              <c:strCache>
                <c:ptCount val="1"/>
                <c:pt idx="0">
                  <c:v>CTR</c:v>
                </c:pt>
              </c:strCache>
            </c:strRef>
          </c:tx>
          <c:spPr>
            <a:ln w="25400">
              <a:solidFill>
                <a:srgbClr val="808080"/>
              </a:solidFill>
              <a:prstDash val="solid"/>
            </a:ln>
          </c:spPr>
          <c:marker>
            <c:spPr>
              <a:solidFill>
                <a:srgbClr val="616161"/>
              </a:solidFill>
              <a:ln>
                <a:solidFill>
                  <a:srgbClr val="80808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ALU-3 GRAPH'!$B$12:$P$12</c:f>
                <c:numCache>
                  <c:formatCode>General</c:formatCode>
                  <c:ptCount val="15"/>
                  <c:pt idx="0">
                    <c:v>9.512976606418046</c:v>
                  </c:pt>
                  <c:pt idx="1">
                    <c:v>12.16560276222122</c:v>
                  </c:pt>
                  <c:pt idx="2">
                    <c:v>14.0909363844261</c:v>
                  </c:pt>
                  <c:pt idx="3">
                    <c:v>15.37436407300338</c:v>
                  </c:pt>
                  <c:pt idx="4">
                    <c:v>19.73060135193301</c:v>
                  </c:pt>
                  <c:pt idx="5">
                    <c:v>25.05827841605825</c:v>
                  </c:pt>
                  <c:pt idx="6">
                    <c:v>31.95698020380655</c:v>
                  </c:pt>
                  <c:pt idx="7">
                    <c:v>24.87286137134037</c:v>
                  </c:pt>
                  <c:pt idx="8">
                    <c:v>15.92467978229658</c:v>
                  </c:pt>
                  <c:pt idx="9">
                    <c:v>13.556969288885</c:v>
                  </c:pt>
                  <c:pt idx="10">
                    <c:v>11.45989239734946</c:v>
                  </c:pt>
                  <c:pt idx="11">
                    <c:v>13.91272866719744</c:v>
                  </c:pt>
                  <c:pt idx="12">
                    <c:v>21.56600724406751</c:v>
                  </c:pt>
                  <c:pt idx="13">
                    <c:v>25.49875362206159</c:v>
                  </c:pt>
                  <c:pt idx="14">
                    <c:v>11.97700808055756</c:v>
                  </c:pt>
                </c:numCache>
              </c:numRef>
            </c:plus>
            <c:spPr>
              <a:ln w="25400">
                <a:solidFill>
                  <a:srgbClr val="808080"/>
                </a:solidFill>
                <a:prstDash val="solid"/>
              </a:ln>
            </c:spPr>
          </c:errBars>
          <c:cat>
            <c:numRef>
              <c:f>'CALU-3 GRAPH'!$B$5:$P$5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CALU-3 GRAPH'!$B$6:$P$6</c:f>
              <c:numCache>
                <c:formatCode>0</c:formatCode>
                <c:ptCount val="15"/>
                <c:pt idx="0">
                  <c:v>75.068565</c:v>
                </c:pt>
                <c:pt idx="1">
                  <c:v>140.8876625</c:v>
                </c:pt>
                <c:pt idx="2">
                  <c:v>145.15475</c:v>
                </c:pt>
                <c:pt idx="3">
                  <c:v>150.48332</c:v>
                </c:pt>
                <c:pt idx="4">
                  <c:v>170.7178525</c:v>
                </c:pt>
                <c:pt idx="5">
                  <c:v>179.94964</c:v>
                </c:pt>
                <c:pt idx="6">
                  <c:v>199.278755</c:v>
                </c:pt>
                <c:pt idx="7">
                  <c:v>209.953965</c:v>
                </c:pt>
                <c:pt idx="8">
                  <c:v>240.23766</c:v>
                </c:pt>
                <c:pt idx="9">
                  <c:v>254.91375</c:v>
                </c:pt>
                <c:pt idx="10">
                  <c:v>280.7112749999998</c:v>
                </c:pt>
                <c:pt idx="11">
                  <c:v>299.4161949999998</c:v>
                </c:pt>
                <c:pt idx="12">
                  <c:v>320.367905</c:v>
                </c:pt>
                <c:pt idx="13">
                  <c:v>350.854075</c:v>
                </c:pt>
                <c:pt idx="14">
                  <c:v>419.770666249999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CALU-3 GRAPH'!$A$7</c:f>
              <c:strCache>
                <c:ptCount val="1"/>
                <c:pt idx="0">
                  <c:v>sorafenib</c:v>
                </c:pt>
              </c:strCache>
            </c:strRef>
          </c:tx>
          <c:spPr>
            <a:ln w="25400">
              <a:solidFill>
                <a:srgbClr val="C0C0C0"/>
              </a:solidFill>
              <a:prstDash val="solid"/>
            </a:ln>
          </c:spPr>
          <c:marker>
            <c:spPr>
              <a:solidFill>
                <a:srgbClr val="B3B3B3"/>
              </a:solidFill>
              <a:ln>
                <a:solidFill>
                  <a:srgbClr val="C0C0C0"/>
                </a:solidFill>
                <a:prstDash val="solid"/>
              </a:ln>
            </c:spPr>
          </c:marker>
          <c:cat>
            <c:numRef>
              <c:f>'CALU-3 GRAPH'!$B$5:$P$5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smooth val="0"/>
        </c:ser>
        <c:ser>
          <c:idx val="2"/>
          <c:order val="2"/>
          <c:tx>
            <c:strRef>
              <c:f>'CALU-3 GRAPH'!$A$8</c:f>
              <c:strCache>
                <c:ptCount val="1"/>
              </c:strCache>
            </c:strRef>
          </c:tx>
          <c:spPr>
            <a:ln w="25400">
              <a:solidFill>
                <a:srgbClr val="C0C0C0"/>
              </a:solidFill>
              <a:prstDash val="solid"/>
            </a:ln>
          </c:spPr>
          <c:marker>
            <c:symbol val="square"/>
            <c:size val="7"/>
            <c:spPr>
              <a:solidFill>
                <a:srgbClr val="BFBFBF"/>
              </a:solidFill>
              <a:ln>
                <a:solidFill>
                  <a:srgbClr val="C0C0C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ALU-3 GRAPH'!$B$13:$P$13</c:f>
                <c:numCache>
                  <c:formatCode>General</c:formatCode>
                  <c:ptCount val="15"/>
                  <c:pt idx="0">
                    <c:v>9.5802908163195</c:v>
                  </c:pt>
                  <c:pt idx="1">
                    <c:v>15.68303251142095</c:v>
                  </c:pt>
                  <c:pt idx="2">
                    <c:v>9.921784909552775</c:v>
                  </c:pt>
                  <c:pt idx="3">
                    <c:v>13.28289162967597</c:v>
                  </c:pt>
                  <c:pt idx="4">
                    <c:v>15.9496327845771</c:v>
                  </c:pt>
                  <c:pt idx="5">
                    <c:v>19.98376454710888</c:v>
                  </c:pt>
                  <c:pt idx="6">
                    <c:v>25.33522929677179</c:v>
                  </c:pt>
                  <c:pt idx="7">
                    <c:v>16.84334112282941</c:v>
                  </c:pt>
                  <c:pt idx="8">
                    <c:v>15.91732894198025</c:v>
                  </c:pt>
                  <c:pt idx="9">
                    <c:v>13.98835044468089</c:v>
                  </c:pt>
                  <c:pt idx="10">
                    <c:v>13.06098242626505</c:v>
                  </c:pt>
                  <c:pt idx="11">
                    <c:v>12.92221007123007</c:v>
                  </c:pt>
                  <c:pt idx="12">
                    <c:v>16.16484099581574</c:v>
                  </c:pt>
                  <c:pt idx="13">
                    <c:v>19.21844050933289</c:v>
                  </c:pt>
                  <c:pt idx="14">
                    <c:v>14.9088340306638</c:v>
                  </c:pt>
                </c:numCache>
              </c:numRef>
            </c:plus>
            <c:spPr>
              <a:ln w="25400">
                <a:solidFill>
                  <a:srgbClr val="C0C0C0"/>
                </a:solidFill>
                <a:prstDash val="solid"/>
              </a:ln>
            </c:spPr>
          </c:errBars>
          <c:cat>
            <c:numRef>
              <c:f>'CALU-3 GRAPH'!$B$5:$P$5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CALU-3 GRAPH'!$B$7:$P$7</c:f>
              <c:numCache>
                <c:formatCode>0</c:formatCode>
                <c:ptCount val="15"/>
                <c:pt idx="0">
                  <c:v>75.03652</c:v>
                </c:pt>
                <c:pt idx="1">
                  <c:v>89.947</c:v>
                </c:pt>
                <c:pt idx="2">
                  <c:v>86.81595</c:v>
                </c:pt>
                <c:pt idx="3">
                  <c:v>93.00589999999998</c:v>
                </c:pt>
                <c:pt idx="4">
                  <c:v>90.58855</c:v>
                </c:pt>
                <c:pt idx="5">
                  <c:v>96.7135</c:v>
                </c:pt>
                <c:pt idx="6">
                  <c:v>100.8462</c:v>
                </c:pt>
                <c:pt idx="7">
                  <c:v>103.28045</c:v>
                </c:pt>
                <c:pt idx="8">
                  <c:v>111.21955</c:v>
                </c:pt>
                <c:pt idx="9">
                  <c:v>118.69442</c:v>
                </c:pt>
                <c:pt idx="10">
                  <c:v>119.68632</c:v>
                </c:pt>
                <c:pt idx="11">
                  <c:v>134.525625</c:v>
                </c:pt>
                <c:pt idx="12">
                  <c:v>142.93045</c:v>
                </c:pt>
                <c:pt idx="13">
                  <c:v>149.3998038</c:v>
                </c:pt>
                <c:pt idx="14">
                  <c:v>160.311482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CALU-3 GRAPH'!$A$9</c:f>
              <c:strCache>
                <c:ptCount val="1"/>
              </c:strCache>
            </c:strRef>
          </c:tx>
          <c:spPr>
            <a:ln w="25400">
              <a:solidFill>
                <a:srgbClr val="333333"/>
              </a:solidFill>
              <a:prstDash val="solid"/>
            </a:ln>
          </c:spPr>
          <c:marker>
            <c:spPr>
              <a:solidFill>
                <a:srgbClr val="505050"/>
              </a:solidFill>
              <a:ln>
                <a:solidFill>
                  <a:srgbClr val="333333"/>
                </a:solidFill>
                <a:prstDash val="solid"/>
              </a:ln>
            </c:spPr>
          </c:marker>
          <c:cat>
            <c:numRef>
              <c:f>'CALU-3 GRAPH'!$B$5:$P$5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CALU-3 GRAPH'!$B$9:$P$9</c:f>
              <c:numCache>
                <c:formatCode>General</c:formatCode>
                <c:ptCount val="15"/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40037784"/>
        <c:axId val="2094242440"/>
      </c:lineChart>
      <c:catAx>
        <c:axId val="-2040037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209424244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094242440"/>
        <c:scaling>
          <c:orientation val="minMax"/>
          <c:max val="600.0"/>
        </c:scaling>
        <c:delete val="0"/>
        <c:axPos val="l"/>
        <c:majorGridlines>
          <c:spPr>
            <a:ln w="3175">
              <a:solidFill>
                <a:srgbClr val="80808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umor size (mm</a:t>
                </a:r>
                <a:r>
                  <a:rPr lang="it-IT" baseline="30000"/>
                  <a:t>3</a:t>
                </a:r>
                <a:r>
                  <a:rPr lang="it-IT"/>
                  <a:t>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-2040037784"/>
        <c:crosses val="autoZero"/>
        <c:crossBetween val="between"/>
        <c:majorUnit val="100.0"/>
        <c:minorUnit val="10.0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it-IT"/>
              <a:t>CALU-3 GEF-R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13502947809916"/>
          <c:y val="0.166717053344921"/>
          <c:w val="0.700586749429184"/>
          <c:h val="0.649289475160991"/>
        </c:manualLayout>
      </c:layout>
      <c:lineChart>
        <c:grouping val="standard"/>
        <c:varyColors val="0"/>
        <c:ser>
          <c:idx val="0"/>
          <c:order val="0"/>
          <c:tx>
            <c:strRef>
              <c:f>'CALU-3 GRAPH'!$A$81</c:f>
              <c:strCache>
                <c:ptCount val="1"/>
                <c:pt idx="0">
                  <c:v>CTR</c:v>
                </c:pt>
              </c:strCache>
            </c:strRef>
          </c:tx>
          <c:spPr>
            <a:ln w="25400">
              <a:solidFill>
                <a:srgbClr val="808080"/>
              </a:solidFill>
              <a:prstDash val="solid"/>
            </a:ln>
          </c:spPr>
          <c:marker>
            <c:spPr>
              <a:solidFill>
                <a:srgbClr val="616161"/>
              </a:solidFill>
              <a:ln>
                <a:solidFill>
                  <a:srgbClr val="80808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ALU-3 GRAPH'!$B$89:$P$89</c:f>
                <c:numCache>
                  <c:formatCode>General</c:formatCode>
                  <c:ptCount val="15"/>
                  <c:pt idx="0">
                    <c:v>11.25808277229551</c:v>
                  </c:pt>
                  <c:pt idx="1">
                    <c:v>26.50192166599023</c:v>
                  </c:pt>
                  <c:pt idx="2">
                    <c:v>7.305314201951115</c:v>
                  </c:pt>
                  <c:pt idx="3">
                    <c:v>13.05828094534324</c:v>
                  </c:pt>
                  <c:pt idx="4">
                    <c:v>5.387560924340986</c:v>
                  </c:pt>
                  <c:pt idx="5">
                    <c:v>21.77792680990283</c:v>
                  </c:pt>
                  <c:pt idx="6">
                    <c:v>15.96048440832346</c:v>
                  </c:pt>
                  <c:pt idx="7">
                    <c:v>14.91643424078383</c:v>
                  </c:pt>
                  <c:pt idx="8">
                    <c:v>14.85673030726098</c:v>
                  </c:pt>
                  <c:pt idx="9">
                    <c:v>24.94044414702763</c:v>
                  </c:pt>
                  <c:pt idx="10">
                    <c:v>13.40102011887414</c:v>
                  </c:pt>
                  <c:pt idx="11">
                    <c:v>16.84317587067212</c:v>
                  </c:pt>
                  <c:pt idx="12">
                    <c:v>17.03680857243851</c:v>
                  </c:pt>
                  <c:pt idx="13">
                    <c:v>7.67168929522787</c:v>
                  </c:pt>
                  <c:pt idx="14">
                    <c:v>11.28667772948828</c:v>
                  </c:pt>
                </c:numCache>
              </c:numRef>
            </c:plus>
            <c:spPr>
              <a:ln w="25400">
                <a:solidFill>
                  <a:srgbClr val="808080"/>
                </a:solidFill>
                <a:prstDash val="solid"/>
              </a:ln>
            </c:spPr>
          </c:errBars>
          <c:cat>
            <c:numRef>
              <c:f>'CALU-3 GRAPH'!$B$80:$P$80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CALU-3 GRAPH'!$B$81:$P$81</c:f>
              <c:numCache>
                <c:formatCode>0</c:formatCode>
                <c:ptCount val="15"/>
                <c:pt idx="0">
                  <c:v>75.741705</c:v>
                </c:pt>
                <c:pt idx="1">
                  <c:v>100.62169</c:v>
                </c:pt>
                <c:pt idx="2">
                  <c:v>149.940115</c:v>
                </c:pt>
                <c:pt idx="3">
                  <c:v>170.474135</c:v>
                </c:pt>
                <c:pt idx="4">
                  <c:v>229.7841</c:v>
                </c:pt>
                <c:pt idx="5">
                  <c:v>267.75437</c:v>
                </c:pt>
                <c:pt idx="6">
                  <c:v>297.5086725</c:v>
                </c:pt>
                <c:pt idx="7">
                  <c:v>337.561965</c:v>
                </c:pt>
                <c:pt idx="8">
                  <c:v>362.5716704999999</c:v>
                </c:pt>
                <c:pt idx="9">
                  <c:v>401.1889569999998</c:v>
                </c:pt>
                <c:pt idx="10">
                  <c:v>449.9132039999998</c:v>
                </c:pt>
                <c:pt idx="11">
                  <c:v>500.2191739999998</c:v>
                </c:pt>
                <c:pt idx="12">
                  <c:v>555.073805</c:v>
                </c:pt>
                <c:pt idx="13">
                  <c:v>620.31359</c:v>
                </c:pt>
                <c:pt idx="14">
                  <c:v>651.273512500000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CALU-3 GRAPH'!$A$82</c:f>
              <c:strCache>
                <c:ptCount val="1"/>
                <c:pt idx="0">
                  <c:v>sorafenib</c:v>
                </c:pt>
              </c:strCache>
            </c:strRef>
          </c:tx>
          <c:spPr>
            <a:ln w="25400">
              <a:solidFill>
                <a:srgbClr val="C0C0C0"/>
              </a:solidFill>
              <a:prstDash val="solid"/>
            </a:ln>
          </c:spPr>
          <c:marker>
            <c:spPr>
              <a:solidFill>
                <a:srgbClr val="B3B3B3"/>
              </a:solidFill>
              <a:ln>
                <a:solidFill>
                  <a:srgbClr val="C0C0C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ALU-3 GRAPH'!$B$90:$P$90</c:f>
                <c:numCache>
                  <c:formatCode>General</c:formatCode>
                  <c:ptCount val="15"/>
                  <c:pt idx="0">
                    <c:v>16.78841828491466</c:v>
                  </c:pt>
                  <c:pt idx="1">
                    <c:v>11.73590134366957</c:v>
                  </c:pt>
                  <c:pt idx="2">
                    <c:v>17.42276693738646</c:v>
                  </c:pt>
                  <c:pt idx="3">
                    <c:v>7.424404028212836</c:v>
                  </c:pt>
                  <c:pt idx="4">
                    <c:v>5.248662229199796</c:v>
                  </c:pt>
                  <c:pt idx="5">
                    <c:v>3.598918717361011</c:v>
                  </c:pt>
                  <c:pt idx="6">
                    <c:v>8.41585795977366</c:v>
                  </c:pt>
                  <c:pt idx="7">
                    <c:v>9.78755459714019</c:v>
                  </c:pt>
                  <c:pt idx="8">
                    <c:v>17.28504385485325</c:v>
                  </c:pt>
                  <c:pt idx="9">
                    <c:v>27.46172285608068</c:v>
                  </c:pt>
                  <c:pt idx="10">
                    <c:v>18.56873166749468</c:v>
                  </c:pt>
                  <c:pt idx="11">
                    <c:v>12.7711122073057</c:v>
                  </c:pt>
                  <c:pt idx="12">
                    <c:v>20.95498526784103</c:v>
                  </c:pt>
                  <c:pt idx="13">
                    <c:v>8.443811823181944</c:v>
                  </c:pt>
                  <c:pt idx="14">
                    <c:v>6.65343201477254</c:v>
                  </c:pt>
                </c:numCache>
              </c:numRef>
            </c:plus>
            <c:spPr>
              <a:ln w="25400">
                <a:solidFill>
                  <a:srgbClr val="C0C0C0"/>
                </a:solidFill>
                <a:prstDash val="solid"/>
              </a:ln>
            </c:spPr>
          </c:errBars>
          <c:cat>
            <c:numRef>
              <c:f>'CALU-3 GRAPH'!$B$80:$P$80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CALU-3 GRAPH'!$B$82:$P$82</c:f>
              <c:numCache>
                <c:formatCode>0</c:formatCode>
                <c:ptCount val="15"/>
                <c:pt idx="0">
                  <c:v>74.98946000000002</c:v>
                </c:pt>
                <c:pt idx="1">
                  <c:v>85.20408</c:v>
                </c:pt>
                <c:pt idx="2">
                  <c:v>86.36478500000001</c:v>
                </c:pt>
                <c:pt idx="3">
                  <c:v>100.006205</c:v>
                </c:pt>
                <c:pt idx="4">
                  <c:v>115.15777</c:v>
                </c:pt>
                <c:pt idx="5">
                  <c:v>118.7576</c:v>
                </c:pt>
                <c:pt idx="6">
                  <c:v>128.85288</c:v>
                </c:pt>
                <c:pt idx="7">
                  <c:v>131.29142</c:v>
                </c:pt>
                <c:pt idx="8">
                  <c:v>138.912735</c:v>
                </c:pt>
                <c:pt idx="9">
                  <c:v>145.287155</c:v>
                </c:pt>
                <c:pt idx="10">
                  <c:v>156.68432</c:v>
                </c:pt>
                <c:pt idx="11">
                  <c:v>172.6978175</c:v>
                </c:pt>
                <c:pt idx="12">
                  <c:v>178.865691875</c:v>
                </c:pt>
                <c:pt idx="13">
                  <c:v>191.3793375</c:v>
                </c:pt>
                <c:pt idx="14">
                  <c:v>198.723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09114472"/>
        <c:axId val="2066612216"/>
      </c:lineChart>
      <c:catAx>
        <c:axId val="2109114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206661221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066612216"/>
        <c:scaling>
          <c:orientation val="minMax"/>
        </c:scaling>
        <c:delete val="0"/>
        <c:axPos val="l"/>
        <c:majorGridlines>
          <c:spPr>
            <a:ln w="3175">
              <a:solidFill>
                <a:srgbClr val="80808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umor size (mm</a:t>
                </a:r>
                <a:r>
                  <a:rPr lang="it-IT" baseline="30000"/>
                  <a:t>3</a:t>
                </a:r>
                <a:r>
                  <a:rPr lang="it-IT"/>
                  <a:t>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2109114472"/>
        <c:crosses val="autoZero"/>
        <c:crossBetween val="between"/>
        <c:minorUnit val="10.0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HCT-116 ERL-R</a:t>
            </a:r>
          </a:p>
        </c:rich>
      </c:tx>
      <c:layout>
        <c:manualLayout>
          <c:xMode val="edge"/>
          <c:yMode val="edge"/>
          <c:x val="0.352826170701265"/>
          <c:y val="0.0267559801470314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13502881192438"/>
          <c:y val="0.180094890920567"/>
          <c:w val="0.700586749429184"/>
          <c:h val="0.649289475160991"/>
        </c:manualLayout>
      </c:layout>
      <c:lineChart>
        <c:grouping val="standard"/>
        <c:varyColors val="0"/>
        <c:ser>
          <c:idx val="0"/>
          <c:order val="0"/>
          <c:tx>
            <c:strRef>
              <c:f>'HCT-116 GRAPH (2)'!$A$42</c:f>
              <c:strCache>
                <c:ptCount val="1"/>
                <c:pt idx="0">
                  <c:v>CTR</c:v>
                </c:pt>
              </c:strCache>
            </c:strRef>
          </c:tx>
          <c:spPr>
            <a:ln w="25400">
              <a:solidFill>
                <a:srgbClr val="808080"/>
              </a:solidFill>
              <a:prstDash val="solid"/>
            </a:ln>
          </c:spPr>
          <c:marker>
            <c:spPr>
              <a:solidFill>
                <a:srgbClr val="616161"/>
              </a:solidFill>
              <a:ln>
                <a:solidFill>
                  <a:srgbClr val="80808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CT-116 GRAPH (2)'!$B$48:$P$48</c:f>
                <c:numCache>
                  <c:formatCode>General</c:formatCode>
                  <c:ptCount val="15"/>
                  <c:pt idx="0">
                    <c:v>5.05953699942424</c:v>
                  </c:pt>
                  <c:pt idx="1">
                    <c:v>6.747939130772199</c:v>
                  </c:pt>
                  <c:pt idx="2">
                    <c:v>7.15669896209088</c:v>
                  </c:pt>
                  <c:pt idx="3">
                    <c:v>15.11365979071715</c:v>
                  </c:pt>
                  <c:pt idx="4">
                    <c:v>26.46231647592493</c:v>
                  </c:pt>
                  <c:pt idx="5">
                    <c:v>8.380970662146363</c:v>
                  </c:pt>
                  <c:pt idx="6">
                    <c:v>16.5502613373652</c:v>
                  </c:pt>
                  <c:pt idx="7">
                    <c:v>16.49576048004627</c:v>
                  </c:pt>
                  <c:pt idx="8">
                    <c:v>25.61287480637731</c:v>
                  </c:pt>
                  <c:pt idx="9">
                    <c:v>14.01159335821836</c:v>
                  </c:pt>
                  <c:pt idx="10">
                    <c:v>17.51151986367429</c:v>
                  </c:pt>
                  <c:pt idx="11">
                    <c:v>32.18657324760743</c:v>
                  </c:pt>
                  <c:pt idx="12">
                    <c:v>32.68528975178761</c:v>
                  </c:pt>
                  <c:pt idx="13">
                    <c:v>44.92277916470055</c:v>
                  </c:pt>
                  <c:pt idx="14">
                    <c:v>55.87467573199044</c:v>
                  </c:pt>
                </c:numCache>
              </c:numRef>
            </c:plus>
            <c:spPr>
              <a:ln w="25400">
                <a:solidFill>
                  <a:srgbClr val="808080"/>
                </a:solidFill>
                <a:prstDash val="solid"/>
              </a:ln>
            </c:spPr>
          </c:errBars>
          <c:cat>
            <c:numRef>
              <c:f>'HCT-116 GRAPH (2)'!$B$41:$P$41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HCT-116 GRAPH (2)'!$B$42:$P$42</c:f>
              <c:numCache>
                <c:formatCode>0</c:formatCode>
                <c:ptCount val="15"/>
                <c:pt idx="0">
                  <c:v>75.69464500000002</c:v>
                </c:pt>
                <c:pt idx="1">
                  <c:v>119.794233</c:v>
                </c:pt>
                <c:pt idx="2">
                  <c:v>150.3383375</c:v>
                </c:pt>
                <c:pt idx="3">
                  <c:v>169.7381855</c:v>
                </c:pt>
                <c:pt idx="4">
                  <c:v>190.4252155</c:v>
                </c:pt>
                <c:pt idx="5">
                  <c:v>220.14044</c:v>
                </c:pt>
                <c:pt idx="6">
                  <c:v>250.27262</c:v>
                </c:pt>
                <c:pt idx="7">
                  <c:v>270.005125</c:v>
                </c:pt>
                <c:pt idx="8">
                  <c:v>289.439657</c:v>
                </c:pt>
                <c:pt idx="9">
                  <c:v>310.323052</c:v>
                </c:pt>
                <c:pt idx="10">
                  <c:v>350.9541164999998</c:v>
                </c:pt>
                <c:pt idx="11">
                  <c:v>395.2870219999999</c:v>
                </c:pt>
                <c:pt idx="12">
                  <c:v>420.3802394999998</c:v>
                </c:pt>
                <c:pt idx="13">
                  <c:v>450.8485215</c:v>
                </c:pt>
                <c:pt idx="14">
                  <c:v>560.1384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HCT-116 GRAPH (2)'!$A$43</c:f>
              <c:strCache>
                <c:ptCount val="1"/>
                <c:pt idx="0">
                  <c:v>sorafenib</c:v>
                </c:pt>
              </c:strCache>
            </c:strRef>
          </c:tx>
          <c:spPr>
            <a:ln w="25400">
              <a:solidFill>
                <a:srgbClr val="C0C0C0"/>
              </a:solidFill>
              <a:prstDash val="solid"/>
            </a:ln>
          </c:spPr>
          <c:marker>
            <c:spPr>
              <a:solidFill>
                <a:srgbClr val="B3B3B3"/>
              </a:solidFill>
              <a:ln>
                <a:solidFill>
                  <a:srgbClr val="C0C0C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CT-116 GRAPH (2)'!$B$49:$P$49</c:f>
                <c:numCache>
                  <c:formatCode>General</c:formatCode>
                  <c:ptCount val="15"/>
                  <c:pt idx="0">
                    <c:v>11.63094705658194</c:v>
                  </c:pt>
                  <c:pt idx="1">
                    <c:v>14.52436413703826</c:v>
                  </c:pt>
                  <c:pt idx="2">
                    <c:v>17.587646264105</c:v>
                  </c:pt>
                  <c:pt idx="3">
                    <c:v>31.73938663487376</c:v>
                  </c:pt>
                  <c:pt idx="4">
                    <c:v>33.34742067126663</c:v>
                  </c:pt>
                  <c:pt idx="5">
                    <c:v>44.7947766742484</c:v>
                  </c:pt>
                  <c:pt idx="6">
                    <c:v>55.67149769421119</c:v>
                  </c:pt>
                  <c:pt idx="7">
                    <c:v>27.85880106555691</c:v>
                  </c:pt>
                  <c:pt idx="8">
                    <c:v>14.6748820167367</c:v>
                  </c:pt>
                  <c:pt idx="9">
                    <c:v>32.28052086991147</c:v>
                  </c:pt>
                  <c:pt idx="10">
                    <c:v>23.4619750508312</c:v>
                  </c:pt>
                  <c:pt idx="11">
                    <c:v>31.66917927900421</c:v>
                  </c:pt>
                  <c:pt idx="12">
                    <c:v>41.427501952196</c:v>
                  </c:pt>
                  <c:pt idx="13">
                    <c:v>19.69696811502495</c:v>
                  </c:pt>
                  <c:pt idx="14">
                    <c:v>11.41309170256662</c:v>
                  </c:pt>
                </c:numCache>
              </c:numRef>
            </c:plus>
            <c:spPr>
              <a:ln w="25400">
                <a:solidFill>
                  <a:srgbClr val="C0C0C0"/>
                </a:solidFill>
                <a:prstDash val="solid"/>
              </a:ln>
            </c:spPr>
          </c:errBars>
          <c:cat>
            <c:numRef>
              <c:f>'HCT-116 GRAPH (2)'!$B$41:$P$41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HCT-116 GRAPH (2)'!$B$43:$P$43</c:f>
              <c:numCache>
                <c:formatCode>0</c:formatCode>
                <c:ptCount val="15"/>
                <c:pt idx="0">
                  <c:v>75.204727</c:v>
                </c:pt>
                <c:pt idx="1">
                  <c:v>86.8665915</c:v>
                </c:pt>
                <c:pt idx="2">
                  <c:v>91.48053849999998</c:v>
                </c:pt>
                <c:pt idx="3">
                  <c:v>94.95871450000001</c:v>
                </c:pt>
                <c:pt idx="4">
                  <c:v>101.91311</c:v>
                </c:pt>
                <c:pt idx="5">
                  <c:v>105.671397</c:v>
                </c:pt>
                <c:pt idx="6">
                  <c:v>110.1071465</c:v>
                </c:pt>
                <c:pt idx="7">
                  <c:v>110.6195675</c:v>
                </c:pt>
                <c:pt idx="8">
                  <c:v>116.78069</c:v>
                </c:pt>
                <c:pt idx="9">
                  <c:v>120.8092925</c:v>
                </c:pt>
                <c:pt idx="10">
                  <c:v>123.76559</c:v>
                </c:pt>
                <c:pt idx="11">
                  <c:v>127.00766</c:v>
                </c:pt>
                <c:pt idx="12">
                  <c:v>130.2481245</c:v>
                </c:pt>
                <c:pt idx="13">
                  <c:v>133.794895</c:v>
                </c:pt>
                <c:pt idx="14">
                  <c:v>138.3831865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27221448"/>
        <c:axId val="-2027218312"/>
      </c:lineChart>
      <c:catAx>
        <c:axId val="-2027221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-202721831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-2027218312"/>
        <c:scaling>
          <c:orientation val="minMax"/>
        </c:scaling>
        <c:delete val="0"/>
        <c:axPos val="l"/>
        <c:majorGridlines>
          <c:spPr>
            <a:ln w="3175">
              <a:solidFill>
                <a:srgbClr val="80808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umor size (mm</a:t>
                </a:r>
                <a:r>
                  <a:rPr lang="it-IT" baseline="30000"/>
                  <a:t>3</a:t>
                </a:r>
                <a:r>
                  <a:rPr lang="it-IT"/>
                  <a:t>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-2027221448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it-IT"/>
              <a:t>HCT-116 GEF-R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13502881192438"/>
          <c:y val="0.180094890920567"/>
          <c:w val="0.700586749429184"/>
          <c:h val="0.649289475160991"/>
        </c:manualLayout>
      </c:layout>
      <c:lineChart>
        <c:grouping val="standard"/>
        <c:varyColors val="0"/>
        <c:ser>
          <c:idx val="0"/>
          <c:order val="0"/>
          <c:tx>
            <c:strRef>
              <c:f>'HCT-116 GRAPH (2)'!$A$81</c:f>
              <c:strCache>
                <c:ptCount val="1"/>
                <c:pt idx="0">
                  <c:v>CTR</c:v>
                </c:pt>
              </c:strCache>
            </c:strRef>
          </c:tx>
          <c:spPr>
            <a:ln w="25400">
              <a:solidFill>
                <a:srgbClr val="808080"/>
              </a:solidFill>
              <a:prstDash val="solid"/>
            </a:ln>
          </c:spPr>
          <c:marker>
            <c:spPr>
              <a:solidFill>
                <a:srgbClr val="616161"/>
              </a:solidFill>
              <a:ln>
                <a:solidFill>
                  <a:srgbClr val="80808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CT-116 GRAPH (2)'!$B$89:$P$89</c:f>
                <c:numCache>
                  <c:formatCode>General</c:formatCode>
                  <c:ptCount val="15"/>
                  <c:pt idx="0">
                    <c:v>8.069781712972844</c:v>
                  </c:pt>
                  <c:pt idx="1">
                    <c:v>16.13767990930164</c:v>
                  </c:pt>
                  <c:pt idx="2">
                    <c:v>16.8247942048322</c:v>
                  </c:pt>
                  <c:pt idx="3">
                    <c:v>20.42804570555887</c:v>
                  </c:pt>
                  <c:pt idx="4">
                    <c:v>11.54816818233038</c:v>
                  </c:pt>
                  <c:pt idx="5">
                    <c:v>19.63546550338305</c:v>
                  </c:pt>
                  <c:pt idx="6">
                    <c:v>7.121663154450446</c:v>
                  </c:pt>
                  <c:pt idx="7">
                    <c:v>22.70163518679359</c:v>
                  </c:pt>
                  <c:pt idx="8">
                    <c:v>16.4624200602135</c:v>
                  </c:pt>
                  <c:pt idx="9">
                    <c:v>15.69441531656847</c:v>
                  </c:pt>
                  <c:pt idx="10">
                    <c:v>22.99768706047917</c:v>
                  </c:pt>
                  <c:pt idx="11">
                    <c:v>7.651883357153855</c:v>
                  </c:pt>
                  <c:pt idx="12">
                    <c:v>8.136033695601733</c:v>
                  </c:pt>
                  <c:pt idx="13">
                    <c:v>14.57990332838395</c:v>
                  </c:pt>
                  <c:pt idx="14">
                    <c:v>20.29693102816707</c:v>
                  </c:pt>
                </c:numCache>
              </c:numRef>
            </c:plus>
            <c:spPr>
              <a:ln w="25400">
                <a:solidFill>
                  <a:srgbClr val="808080"/>
                </a:solidFill>
                <a:prstDash val="solid"/>
              </a:ln>
            </c:spPr>
          </c:errBars>
          <c:cat>
            <c:numRef>
              <c:f>'HCT-116 GRAPH (2)'!$B$80:$P$80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HCT-116 GRAPH (2)'!$B$81:$P$81</c:f>
              <c:numCache>
                <c:formatCode>0</c:formatCode>
                <c:ptCount val="15"/>
                <c:pt idx="0">
                  <c:v>75.35257599999998</c:v>
                </c:pt>
                <c:pt idx="1">
                  <c:v>130.6474325</c:v>
                </c:pt>
                <c:pt idx="2">
                  <c:v>159.8218635</c:v>
                </c:pt>
                <c:pt idx="3">
                  <c:v>198.919266</c:v>
                </c:pt>
                <c:pt idx="4">
                  <c:v>220.10443</c:v>
                </c:pt>
                <c:pt idx="5">
                  <c:v>262.1775975</c:v>
                </c:pt>
                <c:pt idx="6">
                  <c:v>289.897985</c:v>
                </c:pt>
                <c:pt idx="7">
                  <c:v>329.9146903</c:v>
                </c:pt>
                <c:pt idx="8">
                  <c:v>371.4213697999999</c:v>
                </c:pt>
                <c:pt idx="9">
                  <c:v>410.7575355</c:v>
                </c:pt>
                <c:pt idx="10">
                  <c:v>450.2634369999998</c:v>
                </c:pt>
                <c:pt idx="11">
                  <c:v>510.006666</c:v>
                </c:pt>
                <c:pt idx="12">
                  <c:v>560.0926629999998</c:v>
                </c:pt>
                <c:pt idx="13">
                  <c:v>630.3060074999997</c:v>
                </c:pt>
                <c:pt idx="14">
                  <c:v>660.6347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HCT-116 GRAPH (2)'!$A$82</c:f>
              <c:strCache>
                <c:ptCount val="1"/>
                <c:pt idx="0">
                  <c:v>sorafenib</c:v>
                </c:pt>
              </c:strCache>
            </c:strRef>
          </c:tx>
          <c:spPr>
            <a:ln w="25400">
              <a:solidFill>
                <a:srgbClr val="C0C0C0"/>
              </a:solidFill>
              <a:prstDash val="solid"/>
            </a:ln>
          </c:spPr>
          <c:marker>
            <c:spPr>
              <a:solidFill>
                <a:srgbClr val="B3B3B3"/>
              </a:solidFill>
              <a:ln>
                <a:solidFill>
                  <a:srgbClr val="C0C0C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CT-116 GRAPH (2)'!$B$90:$P$90</c:f>
                <c:numCache>
                  <c:formatCode>General</c:formatCode>
                  <c:ptCount val="15"/>
                  <c:pt idx="0">
                    <c:v>6.790533807166897</c:v>
                  </c:pt>
                  <c:pt idx="1">
                    <c:v>8.288383060942248</c:v>
                  </c:pt>
                  <c:pt idx="2">
                    <c:v>16.72443504491303</c:v>
                  </c:pt>
                  <c:pt idx="3">
                    <c:v>15.18016554473918</c:v>
                  </c:pt>
                  <c:pt idx="4">
                    <c:v>23.04646057956829</c:v>
                  </c:pt>
                  <c:pt idx="5">
                    <c:v>24.16706328942744</c:v>
                  </c:pt>
                  <c:pt idx="6">
                    <c:v>24.19914515189546</c:v>
                  </c:pt>
                  <c:pt idx="7">
                    <c:v>26.59199988202661</c:v>
                  </c:pt>
                  <c:pt idx="8">
                    <c:v>21.89187185872539</c:v>
                  </c:pt>
                  <c:pt idx="9">
                    <c:v>20.01147550899084</c:v>
                  </c:pt>
                  <c:pt idx="10">
                    <c:v>16.04848900934356</c:v>
                  </c:pt>
                  <c:pt idx="11">
                    <c:v>32.01565143401302</c:v>
                  </c:pt>
                  <c:pt idx="12">
                    <c:v>43.7733385745798</c:v>
                  </c:pt>
                  <c:pt idx="13">
                    <c:v>35.4049153976967</c:v>
                  </c:pt>
                  <c:pt idx="14">
                    <c:v>23.8878677154983</c:v>
                  </c:pt>
                </c:numCache>
              </c:numRef>
            </c:plus>
            <c:spPr>
              <a:ln w="25400">
                <a:solidFill>
                  <a:srgbClr val="C0C0C0"/>
                </a:solidFill>
                <a:prstDash val="solid"/>
              </a:ln>
            </c:spPr>
          </c:errBars>
          <c:cat>
            <c:numRef>
              <c:f>'HCT-116 GRAPH (2)'!$B$80:$P$80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HCT-116 GRAPH (2)'!$B$82:$P$82</c:f>
              <c:numCache>
                <c:formatCode>0</c:formatCode>
                <c:ptCount val="15"/>
                <c:pt idx="0">
                  <c:v>75.82239599999996</c:v>
                </c:pt>
                <c:pt idx="1">
                  <c:v>85.20187</c:v>
                </c:pt>
                <c:pt idx="2">
                  <c:v>96.961865</c:v>
                </c:pt>
                <c:pt idx="3">
                  <c:v>110.082895</c:v>
                </c:pt>
                <c:pt idx="4">
                  <c:v>121.52569</c:v>
                </c:pt>
                <c:pt idx="5">
                  <c:v>123.74362</c:v>
                </c:pt>
                <c:pt idx="6">
                  <c:v>130.2370875</c:v>
                </c:pt>
                <c:pt idx="7">
                  <c:v>134.9051275</c:v>
                </c:pt>
                <c:pt idx="8">
                  <c:v>139.9948875</c:v>
                </c:pt>
                <c:pt idx="9">
                  <c:v>145.003365</c:v>
                </c:pt>
                <c:pt idx="10">
                  <c:v>151.9677575</c:v>
                </c:pt>
                <c:pt idx="11">
                  <c:v>163.4661925</c:v>
                </c:pt>
                <c:pt idx="12">
                  <c:v>174.4022475</c:v>
                </c:pt>
                <c:pt idx="13">
                  <c:v>180.35017</c:v>
                </c:pt>
                <c:pt idx="14">
                  <c:v>193.8341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27178872"/>
        <c:axId val="-2027175736"/>
      </c:lineChart>
      <c:catAx>
        <c:axId val="-2027178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-202717573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-2027175736"/>
        <c:scaling>
          <c:orientation val="minMax"/>
        </c:scaling>
        <c:delete val="0"/>
        <c:axPos val="l"/>
        <c:majorGridlines>
          <c:spPr>
            <a:ln w="3175">
              <a:solidFill>
                <a:srgbClr val="80808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umor size (mm</a:t>
                </a:r>
                <a:r>
                  <a:rPr lang="it-IT" baseline="30000"/>
                  <a:t>3</a:t>
                </a:r>
                <a:r>
                  <a:rPr lang="it-IT"/>
                  <a:t>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" sourceLinked="1"/>
        <c:majorTickMark val="none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it-IT"/>
          </a:p>
        </c:txPr>
        <c:crossAx val="-2027178872"/>
        <c:crosses val="autoZero"/>
        <c:crossBetween val="between"/>
        <c:minorUnit val="10.0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it-IT"/>
              <a:t>HCT-116 VAN-R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11984363477208"/>
          <c:y val="0.175115601408593"/>
          <c:w val="0.701375750199354"/>
          <c:h val="0.663595963232564"/>
        </c:manualLayout>
      </c:layout>
      <c:lineChart>
        <c:grouping val="standard"/>
        <c:varyColors val="0"/>
        <c:ser>
          <c:idx val="0"/>
          <c:order val="0"/>
          <c:tx>
            <c:strRef>
              <c:f>'HCT-116 GRAPH (2)'!$A$117</c:f>
              <c:strCache>
                <c:ptCount val="1"/>
                <c:pt idx="0">
                  <c:v>CTR</c:v>
                </c:pt>
              </c:strCache>
            </c:strRef>
          </c:tx>
          <c:errBars>
            <c:errDir val="y"/>
            <c:errBarType val="plus"/>
            <c:errValType val="cust"/>
            <c:noEndCap val="0"/>
            <c:plus>
              <c:numRef>
                <c:f>'HCT-116 GRAPH (2)'!$B$125:$P$125</c:f>
                <c:numCache>
                  <c:formatCode>General</c:formatCode>
                  <c:ptCount val="15"/>
                  <c:pt idx="0">
                    <c:v>4.725588696065221</c:v>
                  </c:pt>
                  <c:pt idx="1">
                    <c:v>15.31410852923897</c:v>
                  </c:pt>
                  <c:pt idx="2">
                    <c:v>15.222469851974</c:v>
                  </c:pt>
                  <c:pt idx="3">
                    <c:v>10.03153465746322</c:v>
                  </c:pt>
                  <c:pt idx="4">
                    <c:v>11.99051184439718</c:v>
                  </c:pt>
                  <c:pt idx="5">
                    <c:v>14.91012709965852</c:v>
                  </c:pt>
                  <c:pt idx="6">
                    <c:v>7.600641656219349</c:v>
                  </c:pt>
                  <c:pt idx="7">
                    <c:v>19.64088259639134</c:v>
                  </c:pt>
                  <c:pt idx="8">
                    <c:v>14.12023977029242</c:v>
                  </c:pt>
                  <c:pt idx="9">
                    <c:v>16.52957031125711</c:v>
                  </c:pt>
                  <c:pt idx="10">
                    <c:v>21.74228786269992</c:v>
                  </c:pt>
                  <c:pt idx="11">
                    <c:v>5.271054786157936</c:v>
                  </c:pt>
                  <c:pt idx="12">
                    <c:v>5.342893441805324</c:v>
                  </c:pt>
                  <c:pt idx="13">
                    <c:v>16.35416997642847</c:v>
                  </c:pt>
                  <c:pt idx="14">
                    <c:v>17.8239935968966</c:v>
                  </c:pt>
                </c:numCache>
              </c:numRef>
            </c:plus>
          </c:errBars>
          <c:cat>
            <c:numRef>
              <c:f>'HCT-116 GRAPH (2)'!$B$116:$P$116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HCT-116 GRAPH (2)'!$B$117:$P$117</c:f>
              <c:numCache>
                <c:formatCode>0</c:formatCode>
                <c:ptCount val="15"/>
                <c:pt idx="0">
                  <c:v>75.72073599999997</c:v>
                </c:pt>
                <c:pt idx="1">
                  <c:v>130.5872425</c:v>
                </c:pt>
                <c:pt idx="2">
                  <c:v>159.956485</c:v>
                </c:pt>
                <c:pt idx="3">
                  <c:v>190.65501</c:v>
                </c:pt>
                <c:pt idx="4">
                  <c:v>230.00497</c:v>
                </c:pt>
                <c:pt idx="5">
                  <c:v>270.0780549999998</c:v>
                </c:pt>
                <c:pt idx="6">
                  <c:v>300.508975</c:v>
                </c:pt>
                <c:pt idx="7">
                  <c:v>330.8098950000001</c:v>
                </c:pt>
                <c:pt idx="8">
                  <c:v>360.0438608</c:v>
                </c:pt>
                <c:pt idx="9">
                  <c:v>380.9370825</c:v>
                </c:pt>
                <c:pt idx="10">
                  <c:v>420.6718425</c:v>
                </c:pt>
                <c:pt idx="11">
                  <c:v>449.6826425</c:v>
                </c:pt>
                <c:pt idx="12">
                  <c:v>509.9018014999999</c:v>
                </c:pt>
                <c:pt idx="13">
                  <c:v>580.3813080000001</c:v>
                </c:pt>
                <c:pt idx="14">
                  <c:v>650.936461500000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HCT-116 GRAPH (2)'!$A$118</c:f>
              <c:strCache>
                <c:ptCount val="1"/>
                <c:pt idx="0">
                  <c:v>sorafenib</c:v>
                </c:pt>
              </c:strCache>
            </c:strRef>
          </c:tx>
          <c:errBars>
            <c:errDir val="y"/>
            <c:errBarType val="plus"/>
            <c:errValType val="cust"/>
            <c:noEndCap val="0"/>
            <c:plus>
              <c:numRef>
                <c:f>'HCT-116 GRAPH (2)'!$B$126:$P$126</c:f>
                <c:numCache>
                  <c:formatCode>General</c:formatCode>
                  <c:ptCount val="15"/>
                  <c:pt idx="0">
                    <c:v>7.411744147684517</c:v>
                  </c:pt>
                  <c:pt idx="1">
                    <c:v>7.348864994350688</c:v>
                  </c:pt>
                  <c:pt idx="2">
                    <c:v>16.3913579515965</c:v>
                  </c:pt>
                  <c:pt idx="3">
                    <c:v>15.24028156952463</c:v>
                  </c:pt>
                  <c:pt idx="4">
                    <c:v>21.85810595154634</c:v>
                  </c:pt>
                  <c:pt idx="5">
                    <c:v>22.75395179844904</c:v>
                  </c:pt>
                  <c:pt idx="6">
                    <c:v>22.71086982390521</c:v>
                  </c:pt>
                  <c:pt idx="7">
                    <c:v>24.55812736227957</c:v>
                  </c:pt>
                  <c:pt idx="8">
                    <c:v>20.91716836288444</c:v>
                  </c:pt>
                  <c:pt idx="9">
                    <c:v>19.52055194060946</c:v>
                  </c:pt>
                  <c:pt idx="10">
                    <c:v>15.04675719158878</c:v>
                  </c:pt>
                  <c:pt idx="11">
                    <c:v>28.43341246522863</c:v>
                  </c:pt>
                  <c:pt idx="12">
                    <c:v>43.75804972571649</c:v>
                  </c:pt>
                  <c:pt idx="13">
                    <c:v>35.47671410779692</c:v>
                  </c:pt>
                  <c:pt idx="14">
                    <c:v>27.61822243424513</c:v>
                  </c:pt>
                </c:numCache>
              </c:numRef>
            </c:plus>
          </c:errBars>
          <c:cat>
            <c:numRef>
              <c:f>'HCT-116 GRAPH (2)'!$B$116:$P$116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HCT-116 GRAPH (2)'!$B$118:$P$118</c:f>
              <c:numCache>
                <c:formatCode>0</c:formatCode>
                <c:ptCount val="15"/>
                <c:pt idx="0">
                  <c:v>75.9977075</c:v>
                </c:pt>
                <c:pt idx="1">
                  <c:v>89.97446250000001</c:v>
                </c:pt>
                <c:pt idx="2">
                  <c:v>110.7038075</c:v>
                </c:pt>
                <c:pt idx="3">
                  <c:v>120.5531275</c:v>
                </c:pt>
                <c:pt idx="4">
                  <c:v>125.9200215</c:v>
                </c:pt>
                <c:pt idx="5">
                  <c:v>130.097305</c:v>
                </c:pt>
                <c:pt idx="6">
                  <c:v>134.682405</c:v>
                </c:pt>
                <c:pt idx="7">
                  <c:v>153.97252</c:v>
                </c:pt>
                <c:pt idx="8">
                  <c:v>169.40417</c:v>
                </c:pt>
                <c:pt idx="9">
                  <c:v>180.139765</c:v>
                </c:pt>
                <c:pt idx="10">
                  <c:v>190.70714</c:v>
                </c:pt>
                <c:pt idx="11">
                  <c:v>209.690975</c:v>
                </c:pt>
                <c:pt idx="12">
                  <c:v>220.12029</c:v>
                </c:pt>
                <c:pt idx="13">
                  <c:v>233.098892</c:v>
                </c:pt>
                <c:pt idx="14">
                  <c:v>245.22583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27144904"/>
        <c:axId val="-2027141992"/>
      </c:lineChart>
      <c:catAx>
        <c:axId val="-2027144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-2027141992"/>
        <c:crosses val="autoZero"/>
        <c:auto val="1"/>
        <c:lblAlgn val="ctr"/>
        <c:lblOffset val="100"/>
        <c:noMultiLvlLbl val="0"/>
      </c:catAx>
      <c:valAx>
        <c:axId val="-202714199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umor size (mm3)</a:t>
                </a:r>
              </a:p>
            </c:rich>
          </c:tx>
          <c:layout/>
          <c:overlay val="0"/>
        </c:title>
        <c:numFmt formatCode="0" sourceLinked="1"/>
        <c:majorTickMark val="none"/>
        <c:minorTickMark val="none"/>
        <c:tickLblPos val="nextTo"/>
        <c:crossAx val="-2027144904"/>
        <c:crosses val="autoZero"/>
        <c:crossBetween val="between"/>
        <c:minorUnit val="10.0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it-IT"/>
              <a:t>HCT-116 WT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1328125"/>
          <c:y val="0.180094890920567"/>
          <c:w val="0.701171875"/>
          <c:h val="0.649289475160991"/>
        </c:manualLayout>
      </c:layout>
      <c:lineChart>
        <c:grouping val="standard"/>
        <c:varyColors val="0"/>
        <c:ser>
          <c:idx val="0"/>
          <c:order val="0"/>
          <c:tx>
            <c:strRef>
              <c:f>'HCT-116 GRAPH (2)'!$A$6</c:f>
              <c:strCache>
                <c:ptCount val="1"/>
                <c:pt idx="0">
                  <c:v>CTR</c:v>
                </c:pt>
              </c:strCache>
            </c:strRef>
          </c:tx>
          <c:errBars>
            <c:errDir val="y"/>
            <c:errBarType val="plus"/>
            <c:errValType val="cust"/>
            <c:noEndCap val="0"/>
            <c:plus>
              <c:numRef>
                <c:f>'HCT-116 GRAPH (2)'!$B$12:$P$12</c:f>
                <c:numCache>
                  <c:formatCode>General</c:formatCode>
                  <c:ptCount val="15"/>
                  <c:pt idx="0">
                    <c:v>12.85776555271004</c:v>
                  </c:pt>
                  <c:pt idx="1">
                    <c:v>11.06711876634315</c:v>
                  </c:pt>
                  <c:pt idx="2">
                    <c:v>11.77314464896517</c:v>
                  </c:pt>
                  <c:pt idx="3">
                    <c:v>14.17448750960683</c:v>
                  </c:pt>
                  <c:pt idx="4">
                    <c:v>16.59899109558858</c:v>
                  </c:pt>
                  <c:pt idx="5">
                    <c:v>25.95577371229055</c:v>
                  </c:pt>
                  <c:pt idx="6">
                    <c:v>33.7387308762102</c:v>
                  </c:pt>
                  <c:pt idx="7">
                    <c:v>21.97572944797767</c:v>
                  </c:pt>
                  <c:pt idx="8">
                    <c:v>11.03102184939495</c:v>
                  </c:pt>
                  <c:pt idx="9">
                    <c:v>17.59401927837898</c:v>
                  </c:pt>
                  <c:pt idx="10">
                    <c:v>22.52008894370708</c:v>
                  </c:pt>
                  <c:pt idx="11">
                    <c:v>34.26648167619124</c:v>
                  </c:pt>
                  <c:pt idx="12">
                    <c:v>44.5200309418209</c:v>
                  </c:pt>
                  <c:pt idx="13">
                    <c:v>49.64341485995443</c:v>
                  </c:pt>
                  <c:pt idx="14">
                    <c:v>34.1950627334829</c:v>
                  </c:pt>
                </c:numCache>
              </c:numRef>
            </c:plus>
          </c:errBars>
          <c:cat>
            <c:numRef>
              <c:f>'HCT-116 GRAPH (2)'!$B$5:$P$5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HCT-116 GRAPH (2)'!$B$6:$P$6</c:f>
              <c:numCache>
                <c:formatCode>0</c:formatCode>
                <c:ptCount val="15"/>
                <c:pt idx="0">
                  <c:v>76.08302</c:v>
                </c:pt>
                <c:pt idx="1">
                  <c:v>100.95436</c:v>
                </c:pt>
                <c:pt idx="2">
                  <c:v>130.924885</c:v>
                </c:pt>
                <c:pt idx="3">
                  <c:v>146.1288400000001</c:v>
                </c:pt>
                <c:pt idx="4">
                  <c:v>170.50839</c:v>
                </c:pt>
                <c:pt idx="5">
                  <c:v>195.4749549999999</c:v>
                </c:pt>
                <c:pt idx="6">
                  <c:v>200.311865</c:v>
                </c:pt>
                <c:pt idx="7">
                  <c:v>221.0442649999999</c:v>
                </c:pt>
                <c:pt idx="8">
                  <c:v>250.92054</c:v>
                </c:pt>
                <c:pt idx="9">
                  <c:v>275.442895</c:v>
                </c:pt>
                <c:pt idx="10">
                  <c:v>299.2865472999998</c:v>
                </c:pt>
                <c:pt idx="11">
                  <c:v>310.6210379999998</c:v>
                </c:pt>
                <c:pt idx="12">
                  <c:v>330.0915474999998</c:v>
                </c:pt>
                <c:pt idx="13">
                  <c:v>345.8056836</c:v>
                </c:pt>
                <c:pt idx="14">
                  <c:v>400.3502555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'HCT-116 GRAPH (2)'!$A$8</c:f>
              <c:strCache>
                <c:ptCount val="1"/>
              </c:strCache>
            </c:strRef>
          </c:tx>
          <c:spPr>
            <a:ln>
              <a:solidFill>
                <a:schemeClr val="bg1">
                  <a:lumMod val="65000"/>
                </a:schemeClr>
              </a:solidFill>
            </a:ln>
          </c:spPr>
          <c:marker>
            <c:symbol val="square"/>
            <c:size val="7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HCT-116 GRAPH (2)'!$B$13:$P$13</c:f>
                <c:numCache>
                  <c:formatCode>General</c:formatCode>
                  <c:ptCount val="15"/>
                  <c:pt idx="0">
                    <c:v>1.478870363460667</c:v>
                  </c:pt>
                  <c:pt idx="1">
                    <c:v>4.597023223739715</c:v>
                  </c:pt>
                  <c:pt idx="2">
                    <c:v>12.13718175178095</c:v>
                  </c:pt>
                  <c:pt idx="3">
                    <c:v>15.20875624176334</c:v>
                  </c:pt>
                  <c:pt idx="4">
                    <c:v>19.07272971112948</c:v>
                  </c:pt>
                  <c:pt idx="5">
                    <c:v>21.80613878591574</c:v>
                  </c:pt>
                  <c:pt idx="6">
                    <c:v>23.70519905870502</c:v>
                  </c:pt>
                  <c:pt idx="7">
                    <c:v>18.21352773005206</c:v>
                  </c:pt>
                  <c:pt idx="8">
                    <c:v>31.64459656009091</c:v>
                  </c:pt>
                  <c:pt idx="9">
                    <c:v>22.55066198973604</c:v>
                  </c:pt>
                  <c:pt idx="10">
                    <c:v>21.32044810502692</c:v>
                  </c:pt>
                  <c:pt idx="11">
                    <c:v>24.99201132657483</c:v>
                  </c:pt>
                  <c:pt idx="12">
                    <c:v>17.77159651330459</c:v>
                  </c:pt>
                  <c:pt idx="13">
                    <c:v>25.11847537292929</c:v>
                  </c:pt>
                  <c:pt idx="14">
                    <c:v>32.96543597388718</c:v>
                  </c:pt>
                </c:numCache>
              </c:numRef>
            </c:plus>
          </c:errBars>
          <c:cat>
            <c:numRef>
              <c:f>'HCT-116 GRAPH (2)'!$B$5:$P$5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HCT-116 GRAPH (2)'!$B$7:$P$7</c:f>
              <c:numCache>
                <c:formatCode>0</c:formatCode>
                <c:ptCount val="15"/>
                <c:pt idx="0">
                  <c:v>75.48567000000001</c:v>
                </c:pt>
                <c:pt idx="1">
                  <c:v>76.033126</c:v>
                </c:pt>
                <c:pt idx="2">
                  <c:v>80.7422525</c:v>
                </c:pt>
                <c:pt idx="3">
                  <c:v>84.861101</c:v>
                </c:pt>
                <c:pt idx="4">
                  <c:v>88.925915</c:v>
                </c:pt>
                <c:pt idx="5">
                  <c:v>95.5115525</c:v>
                </c:pt>
                <c:pt idx="6">
                  <c:v>99.249618</c:v>
                </c:pt>
                <c:pt idx="7">
                  <c:v>96.84311</c:v>
                </c:pt>
                <c:pt idx="8">
                  <c:v>110.131164</c:v>
                </c:pt>
                <c:pt idx="9">
                  <c:v>115.3816105</c:v>
                </c:pt>
                <c:pt idx="10">
                  <c:v>120.3898865</c:v>
                </c:pt>
                <c:pt idx="11">
                  <c:v>125.2981925</c:v>
                </c:pt>
                <c:pt idx="12">
                  <c:v>133.9081055</c:v>
                </c:pt>
                <c:pt idx="13">
                  <c:v>140.13493</c:v>
                </c:pt>
                <c:pt idx="14">
                  <c:v>155.2321615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'HCT-116 GRAPH (2)'!$A$9</c:f>
              <c:strCache>
                <c:ptCount val="1"/>
              </c:strCache>
            </c:strRef>
          </c:tx>
          <c:cat>
            <c:numRef>
              <c:f>'HCT-116 GRAPH (2)'!$B$5:$P$5</c:f>
              <c:numCache>
                <c:formatCode>General</c:formatCode>
                <c:ptCount val="15"/>
                <c:pt idx="0">
                  <c:v>0.0</c:v>
                </c:pt>
                <c:pt idx="1">
                  <c:v>6.0</c:v>
                </c:pt>
                <c:pt idx="2">
                  <c:v>8.0</c:v>
                </c:pt>
                <c:pt idx="3">
                  <c:v>10.0</c:v>
                </c:pt>
                <c:pt idx="4">
                  <c:v>13.0</c:v>
                </c:pt>
                <c:pt idx="5">
                  <c:v>15.0</c:v>
                </c:pt>
                <c:pt idx="6">
                  <c:v>17.0</c:v>
                </c:pt>
                <c:pt idx="7">
                  <c:v>19.0</c:v>
                </c:pt>
                <c:pt idx="8">
                  <c:v>21.0</c:v>
                </c:pt>
                <c:pt idx="9">
                  <c:v>23.0</c:v>
                </c:pt>
                <c:pt idx="10">
                  <c:v>26.0</c:v>
                </c:pt>
                <c:pt idx="11">
                  <c:v>28.0</c:v>
                </c:pt>
                <c:pt idx="12">
                  <c:v>30.0</c:v>
                </c:pt>
                <c:pt idx="13">
                  <c:v>33.0</c:v>
                </c:pt>
                <c:pt idx="14">
                  <c:v>35.0</c:v>
                </c:pt>
              </c:numCache>
            </c:numRef>
          </c:cat>
          <c:val>
            <c:numRef>
              <c:f>'HCT-116 GRAPH (2)'!$B$9:$P$9</c:f>
              <c:numCache>
                <c:formatCode>General</c:formatCode>
                <c:ptCount val="15"/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27099976"/>
        <c:axId val="-2027096920"/>
      </c:lineChart>
      <c:catAx>
        <c:axId val="-2027099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/>
            </a:pPr>
            <a:endParaRPr lang="it-IT"/>
          </a:p>
        </c:txPr>
        <c:crossAx val="-202709692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-2027096920"/>
        <c:scaling>
          <c:orientation val="minMax"/>
          <c:max val="600.0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umor size (mm3)</a:t>
                </a:r>
              </a:p>
            </c:rich>
          </c:tx>
          <c:layout/>
          <c:overlay val="0"/>
        </c:title>
        <c:numFmt formatCode="0" sourceLinked="1"/>
        <c:majorTickMark val="none"/>
        <c:minorTickMark val="none"/>
        <c:tickLblPos val="nextTo"/>
        <c:txPr>
          <a:bodyPr rot="0" vert="horz"/>
          <a:lstStyle/>
          <a:p>
            <a:pPr>
              <a:defRPr/>
            </a:pPr>
            <a:endParaRPr lang="it-IT"/>
          </a:p>
        </c:txPr>
        <c:crossAx val="-2027099976"/>
        <c:crosses val="autoZero"/>
        <c:crossBetween val="between"/>
        <c:majorUnit val="100.0"/>
        <c:minorUnit val="10.0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4593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8001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743700" y="228600"/>
            <a:ext cx="2171700" cy="6400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8600" y="228600"/>
            <a:ext cx="6362700" cy="6400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942194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7F6CB3-5BB8-4BF3-9007-BFF71F6FBE72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883076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4C4563-29CB-43D1-8F6B-2D5857DFA822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487834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659621-B196-4234-BA21-7E2D188C5CC5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805683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447800"/>
            <a:ext cx="4038600" cy="4724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447800"/>
            <a:ext cx="4038600" cy="4724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B4C415-4C37-4820-92C0-A319FF2A56CA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277006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4CDC49-730A-4287-803B-D6CE93A738CB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582398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3B5831-399B-4453-8C09-D9FF3D8D7FAB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644550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0FE33A-80D8-4B05-AF1D-58215EEE4B4D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172050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268A5A-5A28-46E3-8BC9-F91D205C1683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2454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550531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BB953F-7A85-4C3D-B338-F91B6A845407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252261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39CB70-5715-45BD-9017-ED7EB54A85CF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270543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11125"/>
            <a:ext cx="2057400" cy="6061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11125"/>
            <a:ext cx="6019800" cy="6061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A1F713-7CFF-4760-BDF1-C92E33DC8E84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5072919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F466F-BDA4-4F18-9C7B-FF0A9A1B0E80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540328"/>
      </p:ext>
    </p:extLst>
  </p:cSld>
  <p:clrMapOvr>
    <a:masterClrMapping/>
  </p:clrMapOvr>
  <p:hf sldNum="0" hdr="0" dt="0"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F607B-A47E-422C-9BEF-122CCDB7C526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622548"/>
      </p:ext>
    </p:extLst>
  </p:cSld>
  <p:clrMapOvr>
    <a:masterClrMapping/>
  </p:clrMapOvr>
  <p:hf sldNum="0" hdr="0" dt="0"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9A7CB-BEE6-4F99-898E-913F06E8E125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199292"/>
      </p:ext>
    </p:extLst>
  </p:cSld>
  <p:clrMapOvr>
    <a:masterClrMapping/>
  </p:clrMapOvr>
  <p:hf sldNum="0" hdr="0" dt="0"/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E300C-6FC5-4FC3-AF1A-075E4F50620D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780880"/>
      </p:ext>
    </p:extLst>
  </p:cSld>
  <p:clrMapOvr>
    <a:masterClrMapping/>
  </p:clrMapOvr>
  <p:hf sldNum="0" hdr="0" dt="0"/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D295D-4A77-4DEB-B04C-9F4282A8BC04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41482"/>
      </p:ext>
    </p:extLst>
  </p:cSld>
  <p:clrMapOvr>
    <a:masterClrMapping/>
  </p:clrMapOvr>
  <p:hf sldNum="0" hdr="0" dt="0"/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28685-4D0C-42D5-8013-B5904CD1FCBC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120975"/>
      </p:ext>
    </p:extLst>
  </p:cSld>
  <p:clrMapOvr>
    <a:masterClrMapping/>
  </p:clrMapOvr>
  <p:hf sldNum="0" hdr="0" dt="0"/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26C0-9885-4BA9-BBFA-A52CBFEBB775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779315"/>
      </p:ext>
    </p:extLst>
  </p:cSld>
  <p:clrMapOvr>
    <a:masterClrMapping/>
  </p:clrMapOvr>
  <p:hf sldNum="0" hd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194706883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E1B38-C5EB-4D66-9137-0AFE9CDEDE8F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584196"/>
      </p:ext>
    </p:extLst>
  </p:cSld>
  <p:clrMapOvr>
    <a:masterClrMapping/>
  </p:clrMapOvr>
  <p:hf sldNum="0" hdr="0" dt="0"/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B613C-1AD7-49D3-885D-F654C5CDBAA6}" type="datetime1">
              <a:rPr lang="en-US" smtClean="0"/>
              <a:pPr/>
              <a:t>31/10/18</a:t>
            </a:fld>
            <a:endParaRPr lang="en-US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028219"/>
      </p:ext>
    </p:extLst>
  </p:cSld>
  <p:clrMapOvr>
    <a:masterClrMapping/>
  </p:clrMapOvr>
  <p:hf sldNum="0" hdr="0" dt="0"/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FB4290-6522-4139-852E-05BD9E7F0D2E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997545"/>
      </p:ext>
    </p:extLst>
  </p:cSld>
  <p:clrMapOvr>
    <a:masterClrMapping/>
  </p:clrMapOvr>
  <p:hf sldNum="0" hdr="0" dt="0"/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955F9-81EA-47C5-8059-9E5C2B437C70}" type="datetime1">
              <a:rPr lang="en-US" smtClean="0"/>
              <a:pPr/>
              <a:t>31/10/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Presented by:</a:t>
            </a:r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B5FEC-A372-421D-A269-587C51D15792}" type="slidenum">
              <a:rPr lang="en-US" smtClean="0"/>
              <a:pPr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285490"/>
      </p:ext>
    </p:extLst>
  </p:cSld>
  <p:clrMapOvr>
    <a:masterClrMapping/>
  </p:clrMapOvr>
  <p:hf sldNum="0" hd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8600" y="1320800"/>
            <a:ext cx="4267200" cy="5308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20800"/>
            <a:ext cx="4267200" cy="5308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4173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005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28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33675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57863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293562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2.xml"/><Relationship Id="rId12" Type="http://schemas.openxmlformats.org/officeDocument/2006/relationships/theme" Target="../theme/theme2.xml"/><Relationship Id="rId1" Type="http://schemas.openxmlformats.org/officeDocument/2006/relationships/slideLayout" Target="../slideLayouts/slideLayout1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33.xml"/><Relationship Id="rId12" Type="http://schemas.openxmlformats.org/officeDocument/2006/relationships/theme" Target="../theme/theme3.xml"/><Relationship Id="rId1" Type="http://schemas.openxmlformats.org/officeDocument/2006/relationships/slideLayout" Target="../slideLayouts/slideLayout23.xml"/><Relationship Id="rId2" Type="http://schemas.openxmlformats.org/officeDocument/2006/relationships/slideLayout" Target="../slideLayouts/slideLayout24.xml"/><Relationship Id="rId3" Type="http://schemas.openxmlformats.org/officeDocument/2006/relationships/slideLayout" Target="../slideLayouts/slideLayout25.xml"/><Relationship Id="rId4" Type="http://schemas.openxmlformats.org/officeDocument/2006/relationships/slideLayout" Target="../slideLayouts/slideLayout26.xml"/><Relationship Id="rId5" Type="http://schemas.openxmlformats.org/officeDocument/2006/relationships/slideLayout" Target="../slideLayouts/slideLayout27.xml"/><Relationship Id="rId6" Type="http://schemas.openxmlformats.org/officeDocument/2006/relationships/slideLayout" Target="../slideLayouts/slideLayout28.xml"/><Relationship Id="rId7" Type="http://schemas.openxmlformats.org/officeDocument/2006/relationships/slideLayout" Target="../slideLayouts/slideLayout29.xml"/><Relationship Id="rId8" Type="http://schemas.openxmlformats.org/officeDocument/2006/relationships/slideLayout" Target="../slideLayouts/slideLayout30.xml"/><Relationship Id="rId9" Type="http://schemas.openxmlformats.org/officeDocument/2006/relationships/slideLayout" Target="../slideLayouts/slideLayout31.xml"/><Relationship Id="rId10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3469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/>
          <p:cNvCxnSpPr/>
          <p:nvPr/>
        </p:nvCxnSpPr>
        <p:spPr>
          <a:xfrm>
            <a:off x="228600" y="1219200"/>
            <a:ext cx="8686800" cy="0"/>
          </a:xfrm>
          <a:prstGeom prst="line">
            <a:avLst/>
          </a:prstGeom>
          <a:ln w="28575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47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228600" y="228600"/>
            <a:ext cx="8686800" cy="939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Click to edit Master title style</a:t>
            </a:r>
          </a:p>
        </p:txBody>
      </p:sp>
      <p:sp>
        <p:nvSpPr>
          <p:cNvPr id="6148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228600" y="1320800"/>
            <a:ext cx="8686800" cy="530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45720" rIns="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</a:p>
        </p:txBody>
      </p:sp>
    </p:spTree>
  </p:cSld>
  <p:clrMap bg1="dk2" tx1="lt1" bg2="dk1" tx2="lt2" accent1="accent1" accent2="accent2" accent3="accent3" accent4="accent4" accent5="accent5" accent6="accent6" hlink="hlink" folHlink="folHlink"/>
  <p:sldLayoutIdLst>
    <p:sldLayoutId id="2147483786" r:id="rId1"/>
    <p:sldLayoutId id="2147483787" r:id="rId2"/>
    <p:sldLayoutId id="2147483788" r:id="rId3"/>
    <p:sldLayoutId id="2147483789" r:id="rId4"/>
    <p:sldLayoutId id="2147483790" r:id="rId5"/>
    <p:sldLayoutId id="2147483791" r:id="rId6"/>
    <p:sldLayoutId id="2147483792" r:id="rId7"/>
    <p:sldLayoutId id="2147483793" r:id="rId8"/>
    <p:sldLayoutId id="2147483794" r:id="rId9"/>
    <p:sldLayoutId id="2147483795" r:id="rId10"/>
    <p:sldLayoutId id="2147483796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cs typeface="Arial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cs typeface="Arial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cs typeface="Arial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cs typeface="Arial" pitchFamily="34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cs typeface="Arial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cs typeface="Arial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cs typeface="Arial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cs typeface="Arial" pitchFamily="34" charset="0"/>
        </a:defRPr>
      </a:lvl9pPr>
    </p:titleStyle>
    <p:bodyStyle>
      <a:lvl1pPr marL="250825" indent="-250825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SzPct val="110000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1pPr>
      <a:lvl2pPr marL="561975" indent="-309563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2pPr>
      <a:lvl3pPr marL="812800" indent="-249238" algn="l" rtl="0" eaLnBrk="0" fontAlgn="base" hangingPunct="0">
        <a:spcBef>
          <a:spcPct val="20000"/>
        </a:spcBef>
        <a:spcAft>
          <a:spcPct val="0"/>
        </a:spcAft>
        <a:buChar char="•"/>
        <a:defRPr sz="2000">
          <a:solidFill>
            <a:schemeClr val="tx1"/>
          </a:solidFill>
          <a:latin typeface="+mn-lt"/>
          <a:cs typeface="+mn-cs"/>
        </a:defRPr>
      </a:lvl3pPr>
      <a:lvl4pPr marL="1101725" indent="-287338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1390650" indent="-287338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1847850" indent="-287338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305050" indent="-287338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2762250" indent="-287338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219450" indent="-287338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rgbClr val="000066"/>
            </a:gs>
            <a:gs pos="100000">
              <a:srgbClr val="000025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111125"/>
            <a:ext cx="8229600" cy="884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717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447800"/>
            <a:ext cx="8229600" cy="472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0" y="6477000"/>
            <a:ext cx="831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100" b="1">
                <a:solidFill>
                  <a:schemeClr val="bg1"/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57E17928-ACB6-4513-9710-0E4D958C2660}" type="slidenum">
              <a:rPr lang="en-US"/>
              <a:pPr>
                <a:defRPr/>
              </a:pPr>
              <a:t>‹n.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97" r:id="rId1"/>
    <p:sldLayoutId id="2147483798" r:id="rId2"/>
    <p:sldLayoutId id="2147483799" r:id="rId3"/>
    <p:sldLayoutId id="2147483800" r:id="rId4"/>
    <p:sldLayoutId id="2147483801" r:id="rId5"/>
    <p:sldLayoutId id="2147483802" r:id="rId6"/>
    <p:sldLayoutId id="2147483803" r:id="rId7"/>
    <p:sldLayoutId id="2147483804" r:id="rId8"/>
    <p:sldLayoutId id="2147483805" r:id="rId9"/>
    <p:sldLayoutId id="2147483806" r:id="rId10"/>
    <p:sldLayoutId id="2147483807" r:id="rId11"/>
  </p:sldLayoutIdLst>
  <p:timing>
    <p:tnLst>
      <p:par>
        <p:cTn xmlns:p14="http://schemas.microsoft.com/office/powerpoint/2010/main" id="1" dur="indefinite" restart="never" nodeType="tmRoot"/>
      </p:par>
    </p:tnLst>
  </p:timing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FFF00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FFF00"/>
          </a:solidFill>
          <a:latin typeface="Arial" pitchFamily="34" charset="0"/>
          <a:cs typeface="Arial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FFF00"/>
          </a:solidFill>
          <a:latin typeface="Arial" pitchFamily="34" charset="0"/>
          <a:cs typeface="Arial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FFF00"/>
          </a:solidFill>
          <a:latin typeface="Arial" pitchFamily="34" charset="0"/>
          <a:cs typeface="Arial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FFFF00"/>
          </a:solidFill>
          <a:latin typeface="Arial" pitchFamily="34" charset="0"/>
          <a:cs typeface="Arial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3600" b="1">
          <a:solidFill>
            <a:srgbClr val="FFFF00"/>
          </a:solidFill>
          <a:latin typeface="Arial" pitchFamily="34" charset="0"/>
          <a:cs typeface="Arial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3600" b="1">
          <a:solidFill>
            <a:srgbClr val="FFFF00"/>
          </a:solidFill>
          <a:latin typeface="Arial" pitchFamily="34" charset="0"/>
          <a:cs typeface="Arial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3600" b="1">
          <a:solidFill>
            <a:srgbClr val="FFFF00"/>
          </a:solidFill>
          <a:latin typeface="Arial" pitchFamily="34" charset="0"/>
          <a:cs typeface="Arial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3600" b="1">
          <a:solidFill>
            <a:srgbClr val="FFFF00"/>
          </a:solidFill>
          <a:latin typeface="Arial" pitchFamily="34" charset="0"/>
          <a:cs typeface="Arial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rgbClr val="99CCFF"/>
        </a:buClr>
        <a:buFont typeface="Arial" pitchFamily="34" charset="0"/>
        <a:buChar char="•"/>
        <a:defRPr sz="24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rgbClr val="99CCFF"/>
        </a:buClr>
        <a:buFont typeface="Arial" pitchFamily="34" charset="0"/>
        <a:buChar char="–"/>
        <a:defRPr sz="2000">
          <a:solidFill>
            <a:schemeClr val="bg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accent2"/>
        </a:buClr>
        <a:buFont typeface="Arial" pitchFamily="34" charset="0"/>
        <a:buChar char="•"/>
        <a:defRPr sz="2000">
          <a:solidFill>
            <a:schemeClr val="bg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lr>
          <a:schemeClr val="accent2"/>
        </a:buClr>
        <a:buFont typeface="Arial" pitchFamily="34" charset="0"/>
        <a:buChar char="–"/>
        <a:defRPr>
          <a:solidFill>
            <a:schemeClr val="bg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lr>
          <a:schemeClr val="accent2"/>
        </a:buClr>
        <a:buFont typeface="Arial" pitchFamily="34" charset="0"/>
        <a:buChar char="»"/>
        <a:defRPr sz="1600">
          <a:solidFill>
            <a:schemeClr val="bg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lr>
          <a:schemeClr val="accent2"/>
        </a:buClr>
        <a:buFont typeface="Arial" pitchFamily="34" charset="0"/>
        <a:buChar char="»"/>
        <a:defRPr sz="1600">
          <a:solidFill>
            <a:schemeClr val="bg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lr>
          <a:schemeClr val="accent2"/>
        </a:buClr>
        <a:buFont typeface="Arial" pitchFamily="34" charset="0"/>
        <a:buChar char="»"/>
        <a:defRPr sz="1600">
          <a:solidFill>
            <a:schemeClr val="bg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lr>
          <a:schemeClr val="accent2"/>
        </a:buClr>
        <a:buFont typeface="Arial" pitchFamily="34" charset="0"/>
        <a:buChar char="»"/>
        <a:defRPr sz="1600">
          <a:solidFill>
            <a:schemeClr val="bg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lr>
          <a:schemeClr val="accent2"/>
        </a:buClr>
        <a:buFont typeface="Arial" pitchFamily="34" charset="0"/>
        <a:buChar char="»"/>
        <a:defRPr sz="1600">
          <a:solidFill>
            <a:schemeClr val="bg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41C37-88C7-9948-9C84-C7A17715DE27}" type="datetimeFigureOut">
              <a:rPr lang="it-IT" smtClean="0"/>
              <a:t>31/10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9E365-7F7F-C844-BF3F-89B3AF25692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7903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1" r:id="rId1"/>
    <p:sldLayoutId id="2147483822" r:id="rId2"/>
    <p:sldLayoutId id="2147483823" r:id="rId3"/>
    <p:sldLayoutId id="2147483824" r:id="rId4"/>
    <p:sldLayoutId id="2147483825" r:id="rId5"/>
    <p:sldLayoutId id="2147483826" r:id="rId6"/>
    <p:sldLayoutId id="2147483827" r:id="rId7"/>
    <p:sldLayoutId id="2147483828" r:id="rId8"/>
    <p:sldLayoutId id="2147483829" r:id="rId9"/>
    <p:sldLayoutId id="2147483830" r:id="rId10"/>
    <p:sldLayoutId id="2147483831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image" Target="../media/image1.png"/><Relationship Id="rId1" Type="http://schemas.openxmlformats.org/officeDocument/2006/relationships/slideLayout" Target="../slideLayouts/slideLayout29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4" Type="http://schemas.openxmlformats.org/officeDocument/2006/relationships/chart" Target="../charts/chart7.xml"/><Relationship Id="rId5" Type="http://schemas.openxmlformats.org/officeDocument/2006/relationships/chart" Target="../charts/chart8.xml"/><Relationship Id="rId6" Type="http://schemas.openxmlformats.org/officeDocument/2006/relationships/image" Target="../media/image1.png"/><Relationship Id="rId1" Type="http://schemas.openxmlformats.org/officeDocument/2006/relationships/slideLayout" Target="../slideLayouts/slideLayout29.xml"/><Relationship Id="rId2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o 4"/>
          <p:cNvGrpSpPr/>
          <p:nvPr/>
        </p:nvGrpSpPr>
        <p:grpSpPr>
          <a:xfrm>
            <a:off x="0" y="0"/>
            <a:ext cx="8791721" cy="6490188"/>
            <a:chOff x="0" y="0"/>
            <a:chExt cx="8791721" cy="6490188"/>
          </a:xfrm>
        </p:grpSpPr>
        <p:sp>
          <p:nvSpPr>
            <p:cNvPr id="3" name="CasellaDiTesto 2"/>
            <p:cNvSpPr txBox="1"/>
            <p:nvPr/>
          </p:nvSpPr>
          <p:spPr>
            <a:xfrm>
              <a:off x="0" y="0"/>
              <a:ext cx="7832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Figure 5</a:t>
              </a:r>
              <a:endParaRPr lang="it-IT" sz="1200" b="1" dirty="0"/>
            </a:p>
          </p:txBody>
        </p:sp>
        <p:graphicFrame>
          <p:nvGraphicFramePr>
            <p:cNvPr id="22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19529367"/>
                </p:ext>
              </p:extLst>
            </p:nvPr>
          </p:nvGraphicFramePr>
          <p:xfrm>
            <a:off x="4651721" y="383233"/>
            <a:ext cx="414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3" name="Grafico 3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74399218"/>
                </p:ext>
              </p:extLst>
            </p:nvPr>
          </p:nvGraphicFramePr>
          <p:xfrm>
            <a:off x="4651721" y="3790188"/>
            <a:ext cx="414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34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65268728"/>
                </p:ext>
              </p:extLst>
            </p:nvPr>
          </p:nvGraphicFramePr>
          <p:xfrm>
            <a:off x="313225" y="403521"/>
            <a:ext cx="414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31990729"/>
                </p:ext>
              </p:extLst>
            </p:nvPr>
          </p:nvGraphicFramePr>
          <p:xfrm>
            <a:off x="313227" y="3790188"/>
            <a:ext cx="414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" name="CasellaDiTesto 1"/>
            <p:cNvSpPr txBox="1"/>
            <p:nvPr/>
          </p:nvSpPr>
          <p:spPr>
            <a:xfrm>
              <a:off x="1929538" y="2857300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days</a:t>
              </a:r>
              <a:endParaRPr lang="it-IT" sz="1000" b="1" dirty="0"/>
            </a:p>
          </p:txBody>
        </p:sp>
        <p:sp>
          <p:nvSpPr>
            <p:cNvPr id="8" name="CasellaDiTesto 7"/>
            <p:cNvSpPr txBox="1"/>
            <p:nvPr/>
          </p:nvSpPr>
          <p:spPr>
            <a:xfrm>
              <a:off x="6266011" y="6243967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days</a:t>
              </a:r>
              <a:endParaRPr lang="it-IT" sz="1000" b="1" dirty="0"/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6262255" y="2842091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days</a:t>
              </a:r>
              <a:endParaRPr lang="it-IT" sz="1000" b="1" dirty="0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929538" y="6243967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days</a:t>
              </a:r>
              <a:endParaRPr lang="it-IT" sz="1000" b="1" dirty="0"/>
            </a:p>
          </p:txBody>
        </p:sp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78525" y="1420574"/>
              <a:ext cx="774700" cy="381000"/>
            </a:xfrm>
            <a:prstGeom prst="rect">
              <a:avLst/>
            </a:prstGeom>
          </p:spPr>
        </p:pic>
        <p:pic>
          <p:nvPicPr>
            <p:cNvPr id="12" name="Immagine 1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017021" y="4924576"/>
              <a:ext cx="774700" cy="381000"/>
            </a:xfrm>
            <a:prstGeom prst="rect">
              <a:avLst/>
            </a:prstGeom>
          </p:spPr>
        </p:pic>
        <p:pic>
          <p:nvPicPr>
            <p:cNvPr id="13" name="Immagine 1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969914" y="1611074"/>
              <a:ext cx="774700" cy="381000"/>
            </a:xfrm>
            <a:prstGeom prst="rect">
              <a:avLst/>
            </a:prstGeom>
          </p:spPr>
        </p:pic>
        <p:pic>
          <p:nvPicPr>
            <p:cNvPr id="14" name="Immagine 1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72849" y="4910705"/>
              <a:ext cx="774700" cy="381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04303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0" y="0"/>
            <a:ext cx="8810710" cy="6490188"/>
            <a:chOff x="0" y="0"/>
            <a:chExt cx="8810710" cy="6490188"/>
          </a:xfrm>
        </p:grpSpPr>
        <p:graphicFrame>
          <p:nvGraphicFramePr>
            <p:cNvPr id="8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67955377"/>
                </p:ext>
              </p:extLst>
            </p:nvPr>
          </p:nvGraphicFramePr>
          <p:xfrm>
            <a:off x="4670710" y="434835"/>
            <a:ext cx="414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9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66990289"/>
                </p:ext>
              </p:extLst>
            </p:nvPr>
          </p:nvGraphicFramePr>
          <p:xfrm>
            <a:off x="435405" y="3739470"/>
            <a:ext cx="414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0" name="Grafico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56001030"/>
                </p:ext>
              </p:extLst>
            </p:nvPr>
          </p:nvGraphicFramePr>
          <p:xfrm>
            <a:off x="4652238" y="3739470"/>
            <a:ext cx="414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3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91737596"/>
                </p:ext>
              </p:extLst>
            </p:nvPr>
          </p:nvGraphicFramePr>
          <p:xfrm>
            <a:off x="333804" y="434835"/>
            <a:ext cx="414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" name="CasellaDiTesto 5"/>
            <p:cNvSpPr txBox="1"/>
            <p:nvPr/>
          </p:nvSpPr>
          <p:spPr>
            <a:xfrm>
              <a:off x="1929538" y="2857300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days</a:t>
              </a:r>
              <a:endParaRPr lang="it-IT" sz="1000" b="1" dirty="0"/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6266011" y="6243967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days</a:t>
              </a:r>
              <a:endParaRPr lang="it-IT" sz="1000" b="1" dirty="0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6262255" y="2842091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days</a:t>
              </a:r>
              <a:endParaRPr lang="it-IT" sz="1000" b="1" dirty="0"/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1929538" y="6243967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days</a:t>
              </a:r>
              <a:endParaRPr lang="it-IT" sz="1000" b="1" dirty="0"/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0" y="0"/>
              <a:ext cx="7832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Figure 6</a:t>
              </a:r>
              <a:endParaRPr lang="it-IT" sz="1200" b="1" dirty="0"/>
            </a:p>
          </p:txBody>
        </p:sp>
        <p:pic>
          <p:nvPicPr>
            <p:cNvPr id="15" name="Immagine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78525" y="1420574"/>
              <a:ext cx="774700" cy="381000"/>
            </a:xfrm>
            <a:prstGeom prst="rect">
              <a:avLst/>
            </a:prstGeom>
          </p:spPr>
        </p:pic>
        <p:pic>
          <p:nvPicPr>
            <p:cNvPr id="16" name="Immagine 1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992361" y="4924576"/>
              <a:ext cx="774700" cy="381000"/>
            </a:xfrm>
            <a:prstGeom prst="rect">
              <a:avLst/>
            </a:prstGeom>
          </p:spPr>
        </p:pic>
        <p:pic>
          <p:nvPicPr>
            <p:cNvPr id="17" name="Immagine 1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969914" y="1611074"/>
              <a:ext cx="774700" cy="381000"/>
            </a:xfrm>
            <a:prstGeom prst="rect">
              <a:avLst/>
            </a:prstGeom>
          </p:spPr>
        </p:pic>
        <p:pic>
          <p:nvPicPr>
            <p:cNvPr id="18" name="Immagine 1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72849" y="4910705"/>
              <a:ext cx="774700" cy="381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94217554"/>
      </p:ext>
    </p:extLst>
  </p:cSld>
  <p:clrMapOvr>
    <a:masterClrMapping/>
  </p:clrMapOvr>
</p:sld>
</file>

<file path=ppt/theme/theme1.xml><?xml version="1.0" encoding="utf-8"?>
<a:theme xmlns:a="http://schemas.openxmlformats.org/drawingml/2006/main" name="10_Default Design">
  <a:themeElements>
    <a:clrScheme name="">
      <a:dk1>
        <a:srgbClr val="969696"/>
      </a:dk1>
      <a:lt1>
        <a:srgbClr val="FFFFFF"/>
      </a:lt1>
      <a:dk2>
        <a:srgbClr val="002850"/>
      </a:dk2>
      <a:lt2>
        <a:srgbClr val="FFC600"/>
      </a:lt2>
      <a:accent1>
        <a:srgbClr val="00BEFF"/>
      </a:accent1>
      <a:accent2>
        <a:srgbClr val="FF6600"/>
      </a:accent2>
      <a:accent3>
        <a:srgbClr val="AAACB3"/>
      </a:accent3>
      <a:accent4>
        <a:srgbClr val="DADADA"/>
      </a:accent4>
      <a:accent5>
        <a:srgbClr val="AADBFF"/>
      </a:accent5>
      <a:accent6>
        <a:srgbClr val="E75C00"/>
      </a:accent6>
      <a:hlink>
        <a:srgbClr val="00CC66"/>
      </a:hlink>
      <a:folHlink>
        <a:srgbClr val="FF66CC"/>
      </a:folHlink>
    </a:clrScheme>
    <a:fontScheme name="10_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10_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0_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0_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0_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0_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0_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0_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0_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0_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0_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0_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0_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0_Default Design 13">
        <a:dk1>
          <a:srgbClr val="000000"/>
        </a:dk1>
        <a:lt1>
          <a:srgbClr val="003399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AAADCA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0_Default Design 14">
        <a:dk1>
          <a:srgbClr val="000000"/>
        </a:dk1>
        <a:lt1>
          <a:srgbClr val="000099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AAAACA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0_Default Design 15">
        <a:dk1>
          <a:srgbClr val="000000"/>
        </a:dk1>
        <a:lt1>
          <a:srgbClr val="003366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AAADB8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0_Default Design 16">
        <a:dk1>
          <a:srgbClr val="808080"/>
        </a:dk1>
        <a:lt1>
          <a:srgbClr val="FFFFFF"/>
        </a:lt1>
        <a:dk2>
          <a:srgbClr val="003366"/>
        </a:dk2>
        <a:lt2>
          <a:srgbClr val="FFFF66"/>
        </a:lt2>
        <a:accent1>
          <a:srgbClr val="BBE0E3"/>
        </a:accent1>
        <a:accent2>
          <a:srgbClr val="333399"/>
        </a:accent2>
        <a:accent3>
          <a:srgbClr val="AAADB8"/>
        </a:accent3>
        <a:accent4>
          <a:srgbClr val="DADADA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ARIAD scientific congress template">
  <a:themeElements>
    <a:clrScheme name="ARIAD scientific congress template 1">
      <a:dk1>
        <a:srgbClr val="DDDDDD"/>
      </a:dk1>
      <a:lt1>
        <a:srgbClr val="FFFFFF"/>
      </a:lt1>
      <a:dk2>
        <a:srgbClr val="000066"/>
      </a:dk2>
      <a:lt2>
        <a:srgbClr val="FFFF00"/>
      </a:lt2>
      <a:accent1>
        <a:srgbClr val="FFFFFF"/>
      </a:accent1>
      <a:accent2>
        <a:srgbClr val="99CCFF"/>
      </a:accent2>
      <a:accent3>
        <a:srgbClr val="FFFFFF"/>
      </a:accent3>
      <a:accent4>
        <a:srgbClr val="BDBDBD"/>
      </a:accent4>
      <a:accent5>
        <a:srgbClr val="FFFFFF"/>
      </a:accent5>
      <a:accent6>
        <a:srgbClr val="8AB9E7"/>
      </a:accent6>
      <a:hlink>
        <a:srgbClr val="FF0000"/>
      </a:hlink>
      <a:folHlink>
        <a:srgbClr val="969696"/>
      </a:folHlink>
    </a:clrScheme>
    <a:fontScheme name="ARIAD scientific congress template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ARIAD scientific congress template 1">
        <a:dk1>
          <a:srgbClr val="DDDDDD"/>
        </a:dk1>
        <a:lt1>
          <a:srgbClr val="FFFFFF"/>
        </a:lt1>
        <a:dk2>
          <a:srgbClr val="000066"/>
        </a:dk2>
        <a:lt2>
          <a:srgbClr val="FFFF00"/>
        </a:lt2>
        <a:accent1>
          <a:srgbClr val="FFFFFF"/>
        </a:accent1>
        <a:accent2>
          <a:srgbClr val="99CCFF"/>
        </a:accent2>
        <a:accent3>
          <a:srgbClr val="FFFFFF"/>
        </a:accent3>
        <a:accent4>
          <a:srgbClr val="BDBDBD"/>
        </a:accent4>
        <a:accent5>
          <a:srgbClr val="FFFFFF"/>
        </a:accent5>
        <a:accent6>
          <a:srgbClr val="8AB9E7"/>
        </a:accent6>
        <a:hlink>
          <a:srgbClr val="FF0000"/>
        </a:hlink>
        <a:folHlink>
          <a:srgbClr val="969696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222</TotalTime>
  <Words>96</Words>
  <Application>Microsoft Macintosh PowerPoint</Application>
  <PresentationFormat>Presentazione su schermo (4:3)</PresentationFormat>
  <Paragraphs>26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3</vt:i4>
      </vt:variant>
      <vt:variant>
        <vt:lpstr>Titoli diapositive</vt:lpstr>
      </vt:variant>
      <vt:variant>
        <vt:i4>2</vt:i4>
      </vt:variant>
    </vt:vector>
  </HeadingPairs>
  <TitlesOfParts>
    <vt:vector size="5" baseType="lpstr">
      <vt:lpstr>10_Default Design</vt:lpstr>
      <vt:lpstr>ARIAD scientific congress template</vt:lpstr>
      <vt:lpstr>Tema di Office</vt:lpstr>
      <vt:lpstr>Presentazione di PowerPoint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Floriana Morgillo</dc:creator>
  <cp:lastModifiedBy>Floriana Morgillo</cp:lastModifiedBy>
  <cp:revision>27</cp:revision>
  <dcterms:created xsi:type="dcterms:W3CDTF">2016-03-23T10:30:53Z</dcterms:created>
  <dcterms:modified xsi:type="dcterms:W3CDTF">2018-10-31T09:33:42Z</dcterms:modified>
</cp:coreProperties>
</file>